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  <p:sldId id="259" r:id="rId3"/>
    <p:sldId id="264" r:id="rId4"/>
    <p:sldId id="258" r:id="rId5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C583156-35A7-45AB-96B4-D26354F51F93}" v="3" dt="2022-03-15T07:29:10.13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0" d="100"/>
          <a:sy n="60" d="100"/>
        </p:scale>
        <p:origin x="289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rances Byrne" userId="0d0641f6-b1a5-4b0a-9327-66807dc904a0" providerId="ADAL" clId="{CC583156-35A7-45AB-96B4-D26354F51F93}"/>
    <pc:docChg chg="custSel addSld delSld modSld">
      <pc:chgData name="Frances Byrne" userId="0d0641f6-b1a5-4b0a-9327-66807dc904a0" providerId="ADAL" clId="{CC583156-35A7-45AB-96B4-D26354F51F93}" dt="2022-03-18T01:31:25.992" v="263" actId="2711"/>
      <pc:docMkLst>
        <pc:docMk/>
      </pc:docMkLst>
      <pc:sldChg chg="modSp mod">
        <pc:chgData name="Frances Byrne" userId="0d0641f6-b1a5-4b0a-9327-66807dc904a0" providerId="ADAL" clId="{CC583156-35A7-45AB-96B4-D26354F51F93}" dt="2022-03-18T01:31:25.992" v="263" actId="2711"/>
        <pc:sldMkLst>
          <pc:docMk/>
          <pc:sldMk cId="2751433307" sldId="258"/>
        </pc:sldMkLst>
        <pc:spChg chg="mod">
          <ac:chgData name="Frances Byrne" userId="0d0641f6-b1a5-4b0a-9327-66807dc904a0" providerId="ADAL" clId="{CC583156-35A7-45AB-96B4-D26354F51F93}" dt="2022-03-15T07:30:56.867" v="193" actId="20577"/>
          <ac:spMkLst>
            <pc:docMk/>
            <pc:sldMk cId="2751433307" sldId="258"/>
            <ac:spMk id="12" creationId="{27846C14-95C6-412B-B622-CEF34062EF1D}"/>
          </ac:spMkLst>
        </pc:spChg>
        <pc:spChg chg="mod">
          <ac:chgData name="Frances Byrne" userId="0d0641f6-b1a5-4b0a-9327-66807dc904a0" providerId="ADAL" clId="{CC583156-35A7-45AB-96B4-D26354F51F93}" dt="2022-03-18T01:31:25.992" v="263" actId="2711"/>
          <ac:spMkLst>
            <pc:docMk/>
            <pc:sldMk cId="2751433307" sldId="258"/>
            <ac:spMk id="13" creationId="{0771DBBF-DA4C-485C-A79D-C390D6B0DB0F}"/>
          </ac:spMkLst>
        </pc:spChg>
      </pc:sldChg>
      <pc:sldChg chg="modSp mod">
        <pc:chgData name="Frances Byrne" userId="0d0641f6-b1a5-4b0a-9327-66807dc904a0" providerId="ADAL" clId="{CC583156-35A7-45AB-96B4-D26354F51F93}" dt="2022-03-18T01:30:59.838" v="261" actId="2711"/>
        <pc:sldMkLst>
          <pc:docMk/>
          <pc:sldMk cId="2454184897" sldId="259"/>
        </pc:sldMkLst>
        <pc:spChg chg="mod">
          <ac:chgData name="Frances Byrne" userId="0d0641f6-b1a5-4b0a-9327-66807dc904a0" providerId="ADAL" clId="{CC583156-35A7-45AB-96B4-D26354F51F93}" dt="2022-03-15T07:28:06.343" v="88" actId="20577"/>
          <ac:spMkLst>
            <pc:docMk/>
            <pc:sldMk cId="2454184897" sldId="259"/>
            <ac:spMk id="4" creationId="{A4859D08-70E3-4347-ABF2-99E68E8487DD}"/>
          </ac:spMkLst>
        </pc:spChg>
        <pc:spChg chg="mod">
          <ac:chgData name="Frances Byrne" userId="0d0641f6-b1a5-4b0a-9327-66807dc904a0" providerId="ADAL" clId="{CC583156-35A7-45AB-96B4-D26354F51F93}" dt="2022-03-18T01:30:59.838" v="261" actId="2711"/>
          <ac:spMkLst>
            <pc:docMk/>
            <pc:sldMk cId="2454184897" sldId="259"/>
            <ac:spMk id="8" creationId="{E1F1F3EE-6D09-42BD-AC5B-DE37DF75C1B4}"/>
          </ac:spMkLst>
        </pc:spChg>
      </pc:sldChg>
      <pc:sldChg chg="addSp modSp mod">
        <pc:chgData name="Frances Byrne" userId="0d0641f6-b1a5-4b0a-9327-66807dc904a0" providerId="ADAL" clId="{CC583156-35A7-45AB-96B4-D26354F51F93}" dt="2022-03-18T01:31:09.138" v="262" actId="2711"/>
        <pc:sldMkLst>
          <pc:docMk/>
          <pc:sldMk cId="1825371211" sldId="264"/>
        </pc:sldMkLst>
        <pc:spChg chg="mod">
          <ac:chgData name="Frances Byrne" userId="0d0641f6-b1a5-4b0a-9327-66807dc904a0" providerId="ADAL" clId="{CC583156-35A7-45AB-96B4-D26354F51F93}" dt="2022-03-15T07:30:01.748" v="151" actId="1037"/>
          <ac:spMkLst>
            <pc:docMk/>
            <pc:sldMk cId="1825371211" sldId="264"/>
            <ac:spMk id="2" creationId="{66A8A4DF-BAFC-4DD6-A30D-E6B098332B7B}"/>
          </ac:spMkLst>
        </pc:spChg>
        <pc:spChg chg="mod">
          <ac:chgData name="Frances Byrne" userId="0d0641f6-b1a5-4b0a-9327-66807dc904a0" providerId="ADAL" clId="{CC583156-35A7-45AB-96B4-D26354F51F93}" dt="2022-03-15T07:30:37.051" v="187" actId="1037"/>
          <ac:spMkLst>
            <pc:docMk/>
            <pc:sldMk cId="1825371211" sldId="264"/>
            <ac:spMk id="20" creationId="{DAFA6394-6149-42DD-B958-DC3706091B7D}"/>
          </ac:spMkLst>
        </pc:spChg>
        <pc:spChg chg="mod">
          <ac:chgData name="Frances Byrne" userId="0d0641f6-b1a5-4b0a-9327-66807dc904a0" providerId="ADAL" clId="{CC583156-35A7-45AB-96B4-D26354F51F93}" dt="2022-03-15T07:30:37.051" v="187" actId="1037"/>
          <ac:spMkLst>
            <pc:docMk/>
            <pc:sldMk cId="1825371211" sldId="264"/>
            <ac:spMk id="21" creationId="{260FA00E-E9CD-4229-82BE-99EAA28CB248}"/>
          </ac:spMkLst>
        </pc:spChg>
        <pc:spChg chg="mod">
          <ac:chgData name="Frances Byrne" userId="0d0641f6-b1a5-4b0a-9327-66807dc904a0" providerId="ADAL" clId="{CC583156-35A7-45AB-96B4-D26354F51F93}" dt="2022-03-15T07:30:43.572" v="189" actId="1076"/>
          <ac:spMkLst>
            <pc:docMk/>
            <pc:sldMk cId="1825371211" sldId="264"/>
            <ac:spMk id="22" creationId="{788B38A4-1FC9-42CA-A6E1-F9D9921E2309}"/>
          </ac:spMkLst>
        </pc:spChg>
        <pc:spChg chg="mod">
          <ac:chgData name="Frances Byrne" userId="0d0641f6-b1a5-4b0a-9327-66807dc904a0" providerId="ADAL" clId="{CC583156-35A7-45AB-96B4-D26354F51F93}" dt="2022-03-15T07:30:37.051" v="187" actId="1037"/>
          <ac:spMkLst>
            <pc:docMk/>
            <pc:sldMk cId="1825371211" sldId="264"/>
            <ac:spMk id="23" creationId="{A8394F28-36BF-4838-B7AE-CE7C914B85D7}"/>
          </ac:spMkLst>
        </pc:spChg>
        <pc:spChg chg="mod">
          <ac:chgData name="Frances Byrne" userId="0d0641f6-b1a5-4b0a-9327-66807dc904a0" providerId="ADAL" clId="{CC583156-35A7-45AB-96B4-D26354F51F93}" dt="2022-03-15T07:30:37.051" v="187" actId="1037"/>
          <ac:spMkLst>
            <pc:docMk/>
            <pc:sldMk cId="1825371211" sldId="264"/>
            <ac:spMk id="24" creationId="{9FA8B0CE-D461-4F99-8AA1-90C4BF8AD59F}"/>
          </ac:spMkLst>
        </pc:spChg>
        <pc:spChg chg="mod">
          <ac:chgData name="Frances Byrne" userId="0d0641f6-b1a5-4b0a-9327-66807dc904a0" providerId="ADAL" clId="{CC583156-35A7-45AB-96B4-D26354F51F93}" dt="2022-03-15T07:30:28.885" v="177" actId="1035"/>
          <ac:spMkLst>
            <pc:docMk/>
            <pc:sldMk cId="1825371211" sldId="264"/>
            <ac:spMk id="31" creationId="{6880DEF3-6FE3-4751-A70F-891109D4E14F}"/>
          </ac:spMkLst>
        </pc:spChg>
        <pc:spChg chg="mod">
          <ac:chgData name="Frances Byrne" userId="0d0641f6-b1a5-4b0a-9327-66807dc904a0" providerId="ADAL" clId="{CC583156-35A7-45AB-96B4-D26354F51F93}" dt="2022-03-15T07:30:10.913" v="164" actId="1035"/>
          <ac:spMkLst>
            <pc:docMk/>
            <pc:sldMk cId="1825371211" sldId="264"/>
            <ac:spMk id="32" creationId="{16642954-BDD2-41E8-BA24-FB39B9B0E1AC}"/>
          </ac:spMkLst>
        </pc:spChg>
        <pc:spChg chg="mod">
          <ac:chgData name="Frances Byrne" userId="0d0641f6-b1a5-4b0a-9327-66807dc904a0" providerId="ADAL" clId="{CC583156-35A7-45AB-96B4-D26354F51F93}" dt="2022-03-15T07:30:12.574" v="165" actId="1035"/>
          <ac:spMkLst>
            <pc:docMk/>
            <pc:sldMk cId="1825371211" sldId="264"/>
            <ac:spMk id="33" creationId="{082CD6D1-BAF3-4E3B-8B8B-3E1CDC831FB0}"/>
          </ac:spMkLst>
        </pc:spChg>
        <pc:spChg chg="mod">
          <ac:chgData name="Frances Byrne" userId="0d0641f6-b1a5-4b0a-9327-66807dc904a0" providerId="ADAL" clId="{CC583156-35A7-45AB-96B4-D26354F51F93}" dt="2022-03-15T07:30:28.885" v="177" actId="1035"/>
          <ac:spMkLst>
            <pc:docMk/>
            <pc:sldMk cId="1825371211" sldId="264"/>
            <ac:spMk id="34" creationId="{669AB743-177A-4E6E-82F4-A5DB76A7B681}"/>
          </ac:spMkLst>
        </pc:spChg>
        <pc:spChg chg="mod">
          <ac:chgData name="Frances Byrne" userId="0d0641f6-b1a5-4b0a-9327-66807dc904a0" providerId="ADAL" clId="{CC583156-35A7-45AB-96B4-D26354F51F93}" dt="2022-03-15T07:30:28.885" v="177" actId="1035"/>
          <ac:spMkLst>
            <pc:docMk/>
            <pc:sldMk cId="1825371211" sldId="264"/>
            <ac:spMk id="39" creationId="{8A8BE13D-322C-428E-8B9A-0AA1B5DC75CC}"/>
          </ac:spMkLst>
        </pc:spChg>
        <pc:spChg chg="mod">
          <ac:chgData name="Frances Byrne" userId="0d0641f6-b1a5-4b0a-9327-66807dc904a0" providerId="ADAL" clId="{CC583156-35A7-45AB-96B4-D26354F51F93}" dt="2022-03-15T07:30:04.542" v="152" actId="122"/>
          <ac:spMkLst>
            <pc:docMk/>
            <pc:sldMk cId="1825371211" sldId="264"/>
            <ac:spMk id="40" creationId="{9AA0C3F8-3C85-465A-A953-9D683B01A989}"/>
          </ac:spMkLst>
        </pc:spChg>
        <pc:spChg chg="add mod">
          <ac:chgData name="Frances Byrne" userId="0d0641f6-b1a5-4b0a-9327-66807dc904a0" providerId="ADAL" clId="{CC583156-35A7-45AB-96B4-D26354F51F93}" dt="2022-03-18T01:31:09.138" v="262" actId="2711"/>
          <ac:spMkLst>
            <pc:docMk/>
            <pc:sldMk cId="1825371211" sldId="264"/>
            <ac:spMk id="43" creationId="{1564EA12-E43D-4EFF-9650-FF97A97594F1}"/>
          </ac:spMkLst>
        </pc:spChg>
        <pc:spChg chg="mod">
          <ac:chgData name="Frances Byrne" userId="0d0641f6-b1a5-4b0a-9327-66807dc904a0" providerId="ADAL" clId="{CC583156-35A7-45AB-96B4-D26354F51F93}" dt="2022-03-15T07:29:23.787" v="130" actId="14100"/>
          <ac:spMkLst>
            <pc:docMk/>
            <pc:sldMk cId="1825371211" sldId="264"/>
            <ac:spMk id="44" creationId="{2195B8C2-07C9-4A78-94BE-7CA7962DC60A}"/>
          </ac:spMkLst>
        </pc:spChg>
        <pc:spChg chg="mod">
          <ac:chgData name="Frances Byrne" userId="0d0641f6-b1a5-4b0a-9327-66807dc904a0" providerId="ADAL" clId="{CC583156-35A7-45AB-96B4-D26354F51F93}" dt="2022-03-15T07:29:23.787" v="130" actId="14100"/>
          <ac:spMkLst>
            <pc:docMk/>
            <pc:sldMk cId="1825371211" sldId="264"/>
            <ac:spMk id="45" creationId="{8B08D881-203D-4C8C-BDC9-39FCC60E0DF1}"/>
          </ac:spMkLst>
        </pc:spChg>
        <pc:spChg chg="mod">
          <ac:chgData name="Frances Byrne" userId="0d0641f6-b1a5-4b0a-9327-66807dc904a0" providerId="ADAL" clId="{CC583156-35A7-45AB-96B4-D26354F51F93}" dt="2022-03-15T07:29:38.828" v="135" actId="1076"/>
          <ac:spMkLst>
            <pc:docMk/>
            <pc:sldMk cId="1825371211" sldId="264"/>
            <ac:spMk id="60" creationId="{31C3A3E4-3354-4D6C-89FF-1911034EFB9A}"/>
          </ac:spMkLst>
        </pc:spChg>
        <pc:spChg chg="mod">
          <ac:chgData name="Frances Byrne" userId="0d0641f6-b1a5-4b0a-9327-66807dc904a0" providerId="ADAL" clId="{CC583156-35A7-45AB-96B4-D26354F51F93}" dt="2022-03-15T07:28:13.859" v="92" actId="20577"/>
          <ac:spMkLst>
            <pc:docMk/>
            <pc:sldMk cId="1825371211" sldId="264"/>
            <ac:spMk id="61" creationId="{BE7C3513-B5E2-4629-855F-9F9EADF3D49D}"/>
          </ac:spMkLst>
        </pc:spChg>
        <pc:spChg chg="mod">
          <ac:chgData name="Frances Byrne" userId="0d0641f6-b1a5-4b0a-9327-66807dc904a0" providerId="ADAL" clId="{CC583156-35A7-45AB-96B4-D26354F51F93}" dt="2022-03-15T07:30:37.051" v="187" actId="1037"/>
          <ac:spMkLst>
            <pc:docMk/>
            <pc:sldMk cId="1825371211" sldId="264"/>
            <ac:spMk id="62" creationId="{3B761B40-3161-44B1-A1B6-B53A5DC17589}"/>
          </ac:spMkLst>
        </pc:spChg>
        <pc:spChg chg="mod">
          <ac:chgData name="Frances Byrne" userId="0d0641f6-b1a5-4b0a-9327-66807dc904a0" providerId="ADAL" clId="{CC583156-35A7-45AB-96B4-D26354F51F93}" dt="2022-03-15T07:29:23.787" v="130" actId="14100"/>
          <ac:spMkLst>
            <pc:docMk/>
            <pc:sldMk cId="1825371211" sldId="264"/>
            <ac:spMk id="63" creationId="{B5993982-7B5C-44C8-B4FB-D97BC7741D28}"/>
          </ac:spMkLst>
        </pc:spChg>
        <pc:picChg chg="mod">
          <ac:chgData name="Frances Byrne" userId="0d0641f6-b1a5-4b0a-9327-66807dc904a0" providerId="ADAL" clId="{CC583156-35A7-45AB-96B4-D26354F51F93}" dt="2022-03-15T07:30:37.051" v="187" actId="1037"/>
          <ac:picMkLst>
            <pc:docMk/>
            <pc:sldMk cId="1825371211" sldId="264"/>
            <ac:picMk id="17" creationId="{AB4CF226-22C3-4AB4-8BB2-D534A4E4A459}"/>
          </ac:picMkLst>
        </pc:picChg>
        <pc:picChg chg="mod">
          <ac:chgData name="Frances Byrne" userId="0d0641f6-b1a5-4b0a-9327-66807dc904a0" providerId="ADAL" clId="{CC583156-35A7-45AB-96B4-D26354F51F93}" dt="2022-03-15T07:30:28.885" v="177" actId="1035"/>
          <ac:picMkLst>
            <pc:docMk/>
            <pc:sldMk cId="1825371211" sldId="264"/>
            <ac:picMk id="30" creationId="{14AE4C4B-A48C-42D5-885D-EB52437000DB}"/>
          </ac:picMkLst>
        </pc:picChg>
        <pc:picChg chg="mod">
          <ac:chgData name="Frances Byrne" userId="0d0641f6-b1a5-4b0a-9327-66807dc904a0" providerId="ADAL" clId="{CC583156-35A7-45AB-96B4-D26354F51F93}" dt="2022-03-15T07:29:23.787" v="130" actId="14100"/>
          <ac:picMkLst>
            <pc:docMk/>
            <pc:sldMk cId="1825371211" sldId="264"/>
            <ac:picMk id="35" creationId="{5A04CD3E-F68E-48C9-B76B-12452DD1EEC9}"/>
          </ac:picMkLst>
        </pc:picChg>
        <pc:picChg chg="mod">
          <ac:chgData name="Frances Byrne" userId="0d0641f6-b1a5-4b0a-9327-66807dc904a0" providerId="ADAL" clId="{CC583156-35A7-45AB-96B4-D26354F51F93}" dt="2022-03-15T07:29:23.787" v="130" actId="14100"/>
          <ac:picMkLst>
            <pc:docMk/>
            <pc:sldMk cId="1825371211" sldId="264"/>
            <ac:picMk id="37" creationId="{65E5458E-AF34-45CB-ABED-45FB714642BA}"/>
          </ac:picMkLst>
        </pc:picChg>
        <pc:picChg chg="mod">
          <ac:chgData name="Frances Byrne" userId="0d0641f6-b1a5-4b0a-9327-66807dc904a0" providerId="ADAL" clId="{CC583156-35A7-45AB-96B4-D26354F51F93}" dt="2022-03-15T07:30:37.051" v="187" actId="1037"/>
          <ac:picMkLst>
            <pc:docMk/>
            <pc:sldMk cId="1825371211" sldId="264"/>
            <ac:picMk id="38" creationId="{54C83C49-B1A8-4C3F-8BE9-BD0FB1F54479}"/>
          </ac:picMkLst>
        </pc:picChg>
        <pc:cxnChg chg="mod">
          <ac:chgData name="Frances Byrne" userId="0d0641f6-b1a5-4b0a-9327-66807dc904a0" providerId="ADAL" clId="{CC583156-35A7-45AB-96B4-D26354F51F93}" dt="2022-03-15T07:30:37.051" v="187" actId="1037"/>
          <ac:cxnSpMkLst>
            <pc:docMk/>
            <pc:sldMk cId="1825371211" sldId="264"/>
            <ac:cxnSpMk id="19" creationId="{7EE2CC85-C3CB-4E6E-BA51-7C387F434715}"/>
          </ac:cxnSpMkLst>
        </pc:cxnChg>
        <pc:cxnChg chg="mod">
          <ac:chgData name="Frances Byrne" userId="0d0641f6-b1a5-4b0a-9327-66807dc904a0" providerId="ADAL" clId="{CC583156-35A7-45AB-96B4-D26354F51F93}" dt="2022-03-15T07:30:28.885" v="177" actId="1035"/>
          <ac:cxnSpMkLst>
            <pc:docMk/>
            <pc:sldMk cId="1825371211" sldId="264"/>
            <ac:cxnSpMk id="36" creationId="{CB7F2044-2B4B-4680-A161-7D9E964F184A}"/>
          </ac:cxnSpMkLst>
        </pc:cxnChg>
        <pc:cxnChg chg="mod">
          <ac:chgData name="Frances Byrne" userId="0d0641f6-b1a5-4b0a-9327-66807dc904a0" providerId="ADAL" clId="{CC583156-35A7-45AB-96B4-D26354F51F93}" dt="2022-03-15T07:29:23.787" v="130" actId="14100"/>
          <ac:cxnSpMkLst>
            <pc:docMk/>
            <pc:sldMk cId="1825371211" sldId="264"/>
            <ac:cxnSpMk id="41" creationId="{E3606089-8807-4712-B16A-9A9E30755651}"/>
          </ac:cxnSpMkLst>
        </pc:cxnChg>
        <pc:cxnChg chg="mod">
          <ac:chgData name="Frances Byrne" userId="0d0641f6-b1a5-4b0a-9327-66807dc904a0" providerId="ADAL" clId="{CC583156-35A7-45AB-96B4-D26354F51F93}" dt="2022-03-15T07:29:23.787" v="130" actId="14100"/>
          <ac:cxnSpMkLst>
            <pc:docMk/>
            <pc:sldMk cId="1825371211" sldId="264"/>
            <ac:cxnSpMk id="42" creationId="{D47FF96F-D58F-4151-9289-5713E50419AA}"/>
          </ac:cxnSpMkLst>
        </pc:cxnChg>
        <pc:cxnChg chg="mod">
          <ac:chgData name="Frances Byrne" userId="0d0641f6-b1a5-4b0a-9327-66807dc904a0" providerId="ADAL" clId="{CC583156-35A7-45AB-96B4-D26354F51F93}" dt="2022-03-15T07:29:23.787" v="130" actId="14100"/>
          <ac:cxnSpMkLst>
            <pc:docMk/>
            <pc:sldMk cId="1825371211" sldId="264"/>
            <ac:cxnSpMk id="47" creationId="{54136F6A-A28A-4FB8-A1A4-5834B83939F8}"/>
          </ac:cxnSpMkLst>
        </pc:cxnChg>
        <pc:cxnChg chg="mod">
          <ac:chgData name="Frances Byrne" userId="0d0641f6-b1a5-4b0a-9327-66807dc904a0" providerId="ADAL" clId="{CC583156-35A7-45AB-96B4-D26354F51F93}" dt="2022-03-15T07:29:23.787" v="130" actId="14100"/>
          <ac:cxnSpMkLst>
            <pc:docMk/>
            <pc:sldMk cId="1825371211" sldId="264"/>
            <ac:cxnSpMk id="49" creationId="{880FDB3D-ABB6-40B8-A4F0-AB1FF867BAF2}"/>
          </ac:cxnSpMkLst>
        </pc:cxnChg>
        <pc:cxnChg chg="mod">
          <ac:chgData name="Frances Byrne" userId="0d0641f6-b1a5-4b0a-9327-66807dc904a0" providerId="ADAL" clId="{CC583156-35A7-45AB-96B4-D26354F51F93}" dt="2022-03-15T07:29:23.787" v="130" actId="14100"/>
          <ac:cxnSpMkLst>
            <pc:docMk/>
            <pc:sldMk cId="1825371211" sldId="264"/>
            <ac:cxnSpMk id="50" creationId="{D3546A1A-8BC7-4045-97C6-069BF6723B23}"/>
          </ac:cxnSpMkLst>
        </pc:cxnChg>
        <pc:cxnChg chg="mod">
          <ac:chgData name="Frances Byrne" userId="0d0641f6-b1a5-4b0a-9327-66807dc904a0" providerId="ADAL" clId="{CC583156-35A7-45AB-96B4-D26354F51F93}" dt="2022-03-15T07:29:42.173" v="136" actId="1076"/>
          <ac:cxnSpMkLst>
            <pc:docMk/>
            <pc:sldMk cId="1825371211" sldId="264"/>
            <ac:cxnSpMk id="54" creationId="{B6279FF9-8E22-49EE-99B1-DBC2674436EF}"/>
          </ac:cxnSpMkLst>
        </pc:cxnChg>
      </pc:sldChg>
      <pc:sldChg chg="delSp modSp del mod">
        <pc:chgData name="Frances Byrne" userId="0d0641f6-b1a5-4b0a-9327-66807dc904a0" providerId="ADAL" clId="{CC583156-35A7-45AB-96B4-D26354F51F93}" dt="2022-03-15T07:30:51.765" v="191" actId="47"/>
        <pc:sldMkLst>
          <pc:docMk/>
          <pc:sldMk cId="524093625" sldId="265"/>
        </pc:sldMkLst>
        <pc:spChg chg="del mod">
          <ac:chgData name="Frances Byrne" userId="0d0641f6-b1a5-4b0a-9327-66807dc904a0" providerId="ADAL" clId="{CC583156-35A7-45AB-96B4-D26354F51F93}" dt="2022-03-15T07:29:08.360" v="127" actId="21"/>
          <ac:spMkLst>
            <pc:docMk/>
            <pc:sldMk cId="524093625" sldId="265"/>
            <ac:spMk id="5" creationId="{2854651C-B118-47E2-97A6-445C84AA0956}"/>
          </ac:spMkLst>
        </pc:spChg>
      </pc:sldChg>
      <pc:sldChg chg="addSp delSp modSp new mod">
        <pc:chgData name="Frances Byrne" userId="0d0641f6-b1a5-4b0a-9327-66807dc904a0" providerId="ADAL" clId="{CC583156-35A7-45AB-96B4-D26354F51F93}" dt="2022-03-18T01:30:48.214" v="260" actId="2711"/>
        <pc:sldMkLst>
          <pc:docMk/>
          <pc:sldMk cId="3009507955" sldId="266"/>
        </pc:sldMkLst>
        <pc:spChg chg="del">
          <ac:chgData name="Frances Byrne" userId="0d0641f6-b1a5-4b0a-9327-66807dc904a0" providerId="ADAL" clId="{CC583156-35A7-45AB-96B4-D26354F51F93}" dt="2022-03-15T07:22:28.506" v="1" actId="478"/>
          <ac:spMkLst>
            <pc:docMk/>
            <pc:sldMk cId="3009507955" sldId="266"/>
            <ac:spMk id="2" creationId="{58857E14-851E-4C93-9E25-DD7728B24943}"/>
          </ac:spMkLst>
        </pc:spChg>
        <pc:spChg chg="del">
          <ac:chgData name="Frances Byrne" userId="0d0641f6-b1a5-4b0a-9327-66807dc904a0" providerId="ADAL" clId="{CC583156-35A7-45AB-96B4-D26354F51F93}" dt="2022-03-15T07:22:28.506" v="1" actId="478"/>
          <ac:spMkLst>
            <pc:docMk/>
            <pc:sldMk cId="3009507955" sldId="266"/>
            <ac:spMk id="3" creationId="{C07D892B-0A0E-4D25-A99D-231EAB4C1645}"/>
          </ac:spMkLst>
        </pc:spChg>
        <pc:spChg chg="add mod">
          <ac:chgData name="Frances Byrne" userId="0d0641f6-b1a5-4b0a-9327-66807dc904a0" providerId="ADAL" clId="{CC583156-35A7-45AB-96B4-D26354F51F93}" dt="2022-03-15T07:27:56.621" v="85" actId="1076"/>
          <ac:spMkLst>
            <pc:docMk/>
            <pc:sldMk cId="3009507955" sldId="266"/>
            <ac:spMk id="4" creationId="{36919B0A-484E-4E36-94F8-95A166192186}"/>
          </ac:spMkLst>
        </pc:spChg>
        <pc:spChg chg="add mod">
          <ac:chgData name="Frances Byrne" userId="0d0641f6-b1a5-4b0a-9327-66807dc904a0" providerId="ADAL" clId="{CC583156-35A7-45AB-96B4-D26354F51F93}" dt="2022-03-15T07:27:52.819" v="84" actId="552"/>
          <ac:spMkLst>
            <pc:docMk/>
            <pc:sldMk cId="3009507955" sldId="266"/>
            <ac:spMk id="5" creationId="{1561F07A-5BD2-4532-8AAD-C766B926C18F}"/>
          </ac:spMkLst>
        </pc:spChg>
        <pc:spChg chg="add mod">
          <ac:chgData name="Frances Byrne" userId="0d0641f6-b1a5-4b0a-9327-66807dc904a0" providerId="ADAL" clId="{CC583156-35A7-45AB-96B4-D26354F51F93}" dt="2022-03-15T07:27:46.483" v="83" actId="552"/>
          <ac:spMkLst>
            <pc:docMk/>
            <pc:sldMk cId="3009507955" sldId="266"/>
            <ac:spMk id="6" creationId="{F261E7CD-FA48-4EE7-83A5-95609F242CE7}"/>
          </ac:spMkLst>
        </pc:spChg>
        <pc:spChg chg="add mod">
          <ac:chgData name="Frances Byrne" userId="0d0641f6-b1a5-4b0a-9327-66807dc904a0" providerId="ADAL" clId="{CC583156-35A7-45AB-96B4-D26354F51F93}" dt="2022-03-15T07:27:52.819" v="84" actId="552"/>
          <ac:spMkLst>
            <pc:docMk/>
            <pc:sldMk cId="3009507955" sldId="266"/>
            <ac:spMk id="10" creationId="{37D33F4C-F11E-4817-9FC1-2A20B53BC3A4}"/>
          </ac:spMkLst>
        </pc:spChg>
        <pc:spChg chg="add mod">
          <ac:chgData name="Frances Byrne" userId="0d0641f6-b1a5-4b0a-9327-66807dc904a0" providerId="ADAL" clId="{CC583156-35A7-45AB-96B4-D26354F51F93}" dt="2022-03-15T07:27:46.483" v="83" actId="552"/>
          <ac:spMkLst>
            <pc:docMk/>
            <pc:sldMk cId="3009507955" sldId="266"/>
            <ac:spMk id="11" creationId="{C3916FE6-823D-4069-954C-DDE04E7C8765}"/>
          </ac:spMkLst>
        </pc:spChg>
        <pc:spChg chg="add mod">
          <ac:chgData name="Frances Byrne" userId="0d0641f6-b1a5-4b0a-9327-66807dc904a0" providerId="ADAL" clId="{CC583156-35A7-45AB-96B4-D26354F51F93}" dt="2022-03-15T07:28:02.578" v="86"/>
          <ac:spMkLst>
            <pc:docMk/>
            <pc:sldMk cId="3009507955" sldId="266"/>
            <ac:spMk id="14" creationId="{56D4FA59-FA5E-4DF0-B1D9-8018840DD176}"/>
          </ac:spMkLst>
        </pc:spChg>
        <pc:spChg chg="add mod">
          <ac:chgData name="Frances Byrne" userId="0d0641f6-b1a5-4b0a-9327-66807dc904a0" providerId="ADAL" clId="{CC583156-35A7-45AB-96B4-D26354F51F93}" dt="2022-03-18T01:30:48.214" v="260" actId="2711"/>
          <ac:spMkLst>
            <pc:docMk/>
            <pc:sldMk cId="3009507955" sldId="266"/>
            <ac:spMk id="16" creationId="{AD085B1C-65B5-4A69-8930-1010EC3E43D8}"/>
          </ac:spMkLst>
        </pc:spChg>
        <pc:picChg chg="add mod">
          <ac:chgData name="Frances Byrne" userId="0d0641f6-b1a5-4b0a-9327-66807dc904a0" providerId="ADAL" clId="{CC583156-35A7-45AB-96B4-D26354F51F93}" dt="2022-03-15T07:27:36.759" v="82" actId="1035"/>
          <ac:picMkLst>
            <pc:docMk/>
            <pc:sldMk cId="3009507955" sldId="266"/>
            <ac:picMk id="7" creationId="{5CAE9AFE-9CB8-464E-92CE-7C6BC2F6D944}"/>
          </ac:picMkLst>
        </pc:picChg>
        <pc:picChg chg="add mod">
          <ac:chgData name="Frances Byrne" userId="0d0641f6-b1a5-4b0a-9327-66807dc904a0" providerId="ADAL" clId="{CC583156-35A7-45AB-96B4-D26354F51F93}" dt="2022-03-15T07:27:36.759" v="82" actId="1035"/>
          <ac:picMkLst>
            <pc:docMk/>
            <pc:sldMk cId="3009507955" sldId="266"/>
            <ac:picMk id="8" creationId="{148F7CC1-AE7B-43EA-A7C4-DED0F2BE6F51}"/>
          </ac:picMkLst>
        </pc:picChg>
        <pc:picChg chg="add mod">
          <ac:chgData name="Frances Byrne" userId="0d0641f6-b1a5-4b0a-9327-66807dc904a0" providerId="ADAL" clId="{CC583156-35A7-45AB-96B4-D26354F51F93}" dt="2022-03-15T07:27:36.759" v="82" actId="1035"/>
          <ac:picMkLst>
            <pc:docMk/>
            <pc:sldMk cId="3009507955" sldId="266"/>
            <ac:picMk id="9" creationId="{71CB104B-FF01-4CD4-B3B9-B72C5719413A}"/>
          </ac:picMkLst>
        </pc:picChg>
        <pc:picChg chg="add mod">
          <ac:chgData name="Frances Byrne" userId="0d0641f6-b1a5-4b0a-9327-66807dc904a0" providerId="ADAL" clId="{CC583156-35A7-45AB-96B4-D26354F51F93}" dt="2022-03-15T07:27:36.759" v="82" actId="1035"/>
          <ac:picMkLst>
            <pc:docMk/>
            <pc:sldMk cId="3009507955" sldId="266"/>
            <ac:picMk id="12" creationId="{3DE28FDC-8CF1-40DE-B8D8-3940B94CE11F}"/>
          </ac:picMkLst>
        </pc:picChg>
        <pc:picChg chg="add mod">
          <ac:chgData name="Frances Byrne" userId="0d0641f6-b1a5-4b0a-9327-66807dc904a0" providerId="ADAL" clId="{CC583156-35A7-45AB-96B4-D26354F51F93}" dt="2022-03-15T07:27:36.759" v="82" actId="1035"/>
          <ac:picMkLst>
            <pc:docMk/>
            <pc:sldMk cId="3009507955" sldId="266"/>
            <ac:picMk id="13" creationId="{A13317F7-128C-4980-9142-A986CB652E95}"/>
          </ac:picMkLst>
        </pc:picChg>
      </pc:sldChg>
    </pc:docChg>
  </pc:docChgLst>
  <pc:docChgLst>
    <pc:chgData name="Frances Byrne" userId="0d0641f6-b1a5-4b0a-9327-66807dc904a0" providerId="ADAL" clId="{C6E7C2F2-8BE3-47FE-8B1D-3AE2D45895C1}"/>
    <pc:docChg chg="custSel addSld delSld modSld">
      <pc:chgData name="Frances Byrne" userId="0d0641f6-b1a5-4b0a-9327-66807dc904a0" providerId="ADAL" clId="{C6E7C2F2-8BE3-47FE-8B1D-3AE2D45895C1}" dt="2022-02-04T00:49:35.412" v="66" actId="1038"/>
      <pc:docMkLst>
        <pc:docMk/>
      </pc:docMkLst>
      <pc:sldChg chg="del">
        <pc:chgData name="Frances Byrne" userId="0d0641f6-b1a5-4b0a-9327-66807dc904a0" providerId="ADAL" clId="{C6E7C2F2-8BE3-47FE-8B1D-3AE2D45895C1}" dt="2022-01-28T05:37:46.280" v="4" actId="47"/>
        <pc:sldMkLst>
          <pc:docMk/>
          <pc:sldMk cId="2667529842" sldId="256"/>
        </pc:sldMkLst>
      </pc:sldChg>
      <pc:sldChg chg="del">
        <pc:chgData name="Frances Byrne" userId="0d0641f6-b1a5-4b0a-9327-66807dc904a0" providerId="ADAL" clId="{C6E7C2F2-8BE3-47FE-8B1D-3AE2D45895C1}" dt="2022-01-28T05:37:49.300" v="7" actId="47"/>
        <pc:sldMkLst>
          <pc:docMk/>
          <pc:sldMk cId="3251763011" sldId="257"/>
        </pc:sldMkLst>
      </pc:sldChg>
      <pc:sldChg chg="addSp modSp mod">
        <pc:chgData name="Frances Byrne" userId="0d0641f6-b1a5-4b0a-9327-66807dc904a0" providerId="ADAL" clId="{C6E7C2F2-8BE3-47FE-8B1D-3AE2D45895C1}" dt="2022-02-04T00:49:35.412" v="66" actId="1038"/>
        <pc:sldMkLst>
          <pc:docMk/>
          <pc:sldMk cId="2751433307" sldId="258"/>
        </pc:sldMkLst>
        <pc:spChg chg="mod">
          <ac:chgData name="Frances Byrne" userId="0d0641f6-b1a5-4b0a-9327-66807dc904a0" providerId="ADAL" clId="{C6E7C2F2-8BE3-47FE-8B1D-3AE2D45895C1}" dt="2022-02-04T00:47:51.761" v="45" actId="1076"/>
          <ac:spMkLst>
            <pc:docMk/>
            <pc:sldMk cId="2751433307" sldId="258"/>
            <ac:spMk id="6" creationId="{9A438D1B-F5E7-4682-8542-11699FA23CE4}"/>
          </ac:spMkLst>
        </pc:spChg>
        <pc:spChg chg="mod">
          <ac:chgData name="Frances Byrne" userId="0d0641f6-b1a5-4b0a-9327-66807dc904a0" providerId="ADAL" clId="{C6E7C2F2-8BE3-47FE-8B1D-3AE2D45895C1}" dt="2022-02-04T00:47:51.761" v="45" actId="1076"/>
          <ac:spMkLst>
            <pc:docMk/>
            <pc:sldMk cId="2751433307" sldId="258"/>
            <ac:spMk id="7" creationId="{8A0A7D16-0E0D-4D58-8329-E1C60363BD34}"/>
          </ac:spMkLst>
        </pc:spChg>
        <pc:spChg chg="mod">
          <ac:chgData name="Frances Byrne" userId="0d0641f6-b1a5-4b0a-9327-66807dc904a0" providerId="ADAL" clId="{C6E7C2F2-8BE3-47FE-8B1D-3AE2D45895C1}" dt="2022-02-04T00:47:51.761" v="45" actId="1076"/>
          <ac:spMkLst>
            <pc:docMk/>
            <pc:sldMk cId="2751433307" sldId="258"/>
            <ac:spMk id="8" creationId="{9C7767EC-D1AF-4CFC-A3DE-CBA8073A2747}"/>
          </ac:spMkLst>
        </pc:spChg>
        <pc:spChg chg="mod">
          <ac:chgData name="Frances Byrne" userId="0d0641f6-b1a5-4b0a-9327-66807dc904a0" providerId="ADAL" clId="{C6E7C2F2-8BE3-47FE-8B1D-3AE2D45895C1}" dt="2022-02-04T00:47:51.761" v="45" actId="1076"/>
          <ac:spMkLst>
            <pc:docMk/>
            <pc:sldMk cId="2751433307" sldId="258"/>
            <ac:spMk id="9" creationId="{924797C1-4C7C-437F-8CED-D4E72DCD042D}"/>
          </ac:spMkLst>
        </pc:spChg>
        <pc:spChg chg="mod">
          <ac:chgData name="Frances Byrne" userId="0d0641f6-b1a5-4b0a-9327-66807dc904a0" providerId="ADAL" clId="{C6E7C2F2-8BE3-47FE-8B1D-3AE2D45895C1}" dt="2022-02-04T00:49:35.412" v="66" actId="1038"/>
          <ac:spMkLst>
            <pc:docMk/>
            <pc:sldMk cId="2751433307" sldId="258"/>
            <ac:spMk id="12" creationId="{27846C14-95C6-412B-B622-CEF34062EF1D}"/>
          </ac:spMkLst>
        </pc:spChg>
        <pc:spChg chg="add mod">
          <ac:chgData name="Frances Byrne" userId="0d0641f6-b1a5-4b0a-9327-66807dc904a0" providerId="ADAL" clId="{C6E7C2F2-8BE3-47FE-8B1D-3AE2D45895C1}" dt="2022-02-04T00:47:48.129" v="44" actId="1076"/>
          <ac:spMkLst>
            <pc:docMk/>
            <pc:sldMk cId="2751433307" sldId="258"/>
            <ac:spMk id="13" creationId="{0771DBBF-DA4C-485C-A79D-C390D6B0DB0F}"/>
          </ac:spMkLst>
        </pc:spChg>
        <pc:picChg chg="mod">
          <ac:chgData name="Frances Byrne" userId="0d0641f6-b1a5-4b0a-9327-66807dc904a0" providerId="ADAL" clId="{C6E7C2F2-8BE3-47FE-8B1D-3AE2D45895C1}" dt="2022-02-04T00:47:51.761" v="45" actId="1076"/>
          <ac:picMkLst>
            <pc:docMk/>
            <pc:sldMk cId="2751433307" sldId="258"/>
            <ac:picMk id="4" creationId="{369EE20F-8F24-4CF8-AE6F-545958732703}"/>
          </ac:picMkLst>
        </pc:picChg>
        <pc:picChg chg="mod">
          <ac:chgData name="Frances Byrne" userId="0d0641f6-b1a5-4b0a-9327-66807dc904a0" providerId="ADAL" clId="{C6E7C2F2-8BE3-47FE-8B1D-3AE2D45895C1}" dt="2022-02-04T00:47:51.761" v="45" actId="1076"/>
          <ac:picMkLst>
            <pc:docMk/>
            <pc:sldMk cId="2751433307" sldId="258"/>
            <ac:picMk id="5" creationId="{8909B00D-56E5-4249-85E9-2AF7EB295A48}"/>
          </ac:picMkLst>
        </pc:picChg>
        <pc:picChg chg="mod">
          <ac:chgData name="Frances Byrne" userId="0d0641f6-b1a5-4b0a-9327-66807dc904a0" providerId="ADAL" clId="{C6E7C2F2-8BE3-47FE-8B1D-3AE2D45895C1}" dt="2022-02-04T00:47:51.761" v="45" actId="1076"/>
          <ac:picMkLst>
            <pc:docMk/>
            <pc:sldMk cId="2751433307" sldId="258"/>
            <ac:picMk id="10" creationId="{59E9B30E-4254-4FC0-8549-A5CAAA31A03E}"/>
          </ac:picMkLst>
        </pc:picChg>
        <pc:picChg chg="mod">
          <ac:chgData name="Frances Byrne" userId="0d0641f6-b1a5-4b0a-9327-66807dc904a0" providerId="ADAL" clId="{C6E7C2F2-8BE3-47FE-8B1D-3AE2D45895C1}" dt="2022-02-04T00:47:51.761" v="45" actId="1076"/>
          <ac:picMkLst>
            <pc:docMk/>
            <pc:sldMk cId="2751433307" sldId="258"/>
            <ac:picMk id="11" creationId="{890F4837-85C5-42DF-9900-14FDCCF28159}"/>
          </ac:picMkLst>
        </pc:picChg>
      </pc:sldChg>
      <pc:sldChg chg="addSp modSp mod">
        <pc:chgData name="Frances Byrne" userId="0d0641f6-b1a5-4b0a-9327-66807dc904a0" providerId="ADAL" clId="{C6E7C2F2-8BE3-47FE-8B1D-3AE2D45895C1}" dt="2022-02-04T00:49:26.276" v="61" actId="1035"/>
        <pc:sldMkLst>
          <pc:docMk/>
          <pc:sldMk cId="2454184897" sldId="259"/>
        </pc:sldMkLst>
        <pc:spChg chg="mod">
          <ac:chgData name="Frances Byrne" userId="0d0641f6-b1a5-4b0a-9327-66807dc904a0" providerId="ADAL" clId="{C6E7C2F2-8BE3-47FE-8B1D-3AE2D45895C1}" dt="2022-02-04T00:49:26.276" v="61" actId="1035"/>
          <ac:spMkLst>
            <pc:docMk/>
            <pc:sldMk cId="2454184897" sldId="259"/>
            <ac:spMk id="4" creationId="{A4859D08-70E3-4347-ABF2-99E68E8487DD}"/>
          </ac:spMkLst>
        </pc:spChg>
        <pc:spChg chg="mod">
          <ac:chgData name="Frances Byrne" userId="0d0641f6-b1a5-4b0a-9327-66807dc904a0" providerId="ADAL" clId="{C6E7C2F2-8BE3-47FE-8B1D-3AE2D45895C1}" dt="2022-02-04T00:46:42.897" v="23" actId="1076"/>
          <ac:spMkLst>
            <pc:docMk/>
            <pc:sldMk cId="2454184897" sldId="259"/>
            <ac:spMk id="5" creationId="{9D445544-0B77-49AB-8349-FE87A0231A50}"/>
          </ac:spMkLst>
        </pc:spChg>
        <pc:spChg chg="mod">
          <ac:chgData name="Frances Byrne" userId="0d0641f6-b1a5-4b0a-9327-66807dc904a0" providerId="ADAL" clId="{C6E7C2F2-8BE3-47FE-8B1D-3AE2D45895C1}" dt="2022-02-04T00:46:42.897" v="23" actId="1076"/>
          <ac:spMkLst>
            <pc:docMk/>
            <pc:sldMk cId="2454184897" sldId="259"/>
            <ac:spMk id="6" creationId="{63E07812-3056-473B-B8E5-94C86B14A4AF}"/>
          </ac:spMkLst>
        </pc:spChg>
        <pc:spChg chg="add mod">
          <ac:chgData name="Frances Byrne" userId="0d0641f6-b1a5-4b0a-9327-66807dc904a0" providerId="ADAL" clId="{C6E7C2F2-8BE3-47FE-8B1D-3AE2D45895C1}" dt="2022-02-04T00:47:20.681" v="36" actId="14100"/>
          <ac:spMkLst>
            <pc:docMk/>
            <pc:sldMk cId="2454184897" sldId="259"/>
            <ac:spMk id="8" creationId="{E1F1F3EE-6D09-42BD-AC5B-DE37DF75C1B4}"/>
          </ac:spMkLst>
        </pc:spChg>
        <pc:picChg chg="mod">
          <ac:chgData name="Frances Byrne" userId="0d0641f6-b1a5-4b0a-9327-66807dc904a0" providerId="ADAL" clId="{C6E7C2F2-8BE3-47FE-8B1D-3AE2D45895C1}" dt="2022-02-04T00:46:42.897" v="23" actId="1076"/>
          <ac:picMkLst>
            <pc:docMk/>
            <pc:sldMk cId="2454184897" sldId="259"/>
            <ac:picMk id="10" creationId="{B960FE9D-1B16-4C58-B4FB-3F2A497CB7D8}"/>
          </ac:picMkLst>
        </pc:picChg>
        <pc:picChg chg="mod">
          <ac:chgData name="Frances Byrne" userId="0d0641f6-b1a5-4b0a-9327-66807dc904a0" providerId="ADAL" clId="{C6E7C2F2-8BE3-47FE-8B1D-3AE2D45895C1}" dt="2022-02-04T00:46:42.897" v="23" actId="1076"/>
          <ac:picMkLst>
            <pc:docMk/>
            <pc:sldMk cId="2454184897" sldId="259"/>
            <ac:picMk id="11" creationId="{7E6A570F-2AA8-4756-94CF-DB685A805950}"/>
          </ac:picMkLst>
        </pc:picChg>
      </pc:sldChg>
      <pc:sldChg chg="del">
        <pc:chgData name="Frances Byrne" userId="0d0641f6-b1a5-4b0a-9327-66807dc904a0" providerId="ADAL" clId="{C6E7C2F2-8BE3-47FE-8B1D-3AE2D45895C1}" dt="2022-01-28T05:37:47.289" v="5" actId="47"/>
        <pc:sldMkLst>
          <pc:docMk/>
          <pc:sldMk cId="4078922079" sldId="260"/>
        </pc:sldMkLst>
      </pc:sldChg>
      <pc:sldChg chg="del">
        <pc:chgData name="Frances Byrne" userId="0d0641f6-b1a5-4b0a-9327-66807dc904a0" providerId="ADAL" clId="{C6E7C2F2-8BE3-47FE-8B1D-3AE2D45895C1}" dt="2022-01-28T05:37:48.272" v="6" actId="47"/>
        <pc:sldMkLst>
          <pc:docMk/>
          <pc:sldMk cId="2188487594" sldId="261"/>
        </pc:sldMkLst>
      </pc:sldChg>
      <pc:sldChg chg="modSp mod">
        <pc:chgData name="Frances Byrne" userId="0d0641f6-b1a5-4b0a-9327-66807dc904a0" providerId="ADAL" clId="{C6E7C2F2-8BE3-47FE-8B1D-3AE2D45895C1}" dt="2022-02-04T00:49:13.072" v="47" actId="1076"/>
        <pc:sldMkLst>
          <pc:docMk/>
          <pc:sldMk cId="1825371211" sldId="264"/>
        </pc:sldMkLst>
        <pc:spChg chg="mod">
          <ac:chgData name="Frances Byrne" userId="0d0641f6-b1a5-4b0a-9327-66807dc904a0" providerId="ADAL" clId="{C6E7C2F2-8BE3-47FE-8B1D-3AE2D45895C1}" dt="2022-02-04T00:49:13.072" v="47" actId="1076"/>
          <ac:spMkLst>
            <pc:docMk/>
            <pc:sldMk cId="1825371211" sldId="264"/>
            <ac:spMk id="61" creationId="{BE7C3513-B5E2-4629-855F-9F9EADF3D49D}"/>
          </ac:spMkLst>
        </pc:spChg>
      </pc:sldChg>
      <pc:sldChg chg="addSp delSp modSp new mod">
        <pc:chgData name="Frances Byrne" userId="0d0641f6-b1a5-4b0a-9327-66807dc904a0" providerId="ADAL" clId="{C6E7C2F2-8BE3-47FE-8B1D-3AE2D45895C1}" dt="2022-02-04T00:47:09.328" v="32" actId="1076"/>
        <pc:sldMkLst>
          <pc:docMk/>
          <pc:sldMk cId="524093625" sldId="265"/>
        </pc:sldMkLst>
        <pc:spChg chg="del">
          <ac:chgData name="Frances Byrne" userId="0d0641f6-b1a5-4b0a-9327-66807dc904a0" providerId="ADAL" clId="{C6E7C2F2-8BE3-47FE-8B1D-3AE2D45895C1}" dt="2022-01-28T05:37:54.939" v="8" actId="478"/>
          <ac:spMkLst>
            <pc:docMk/>
            <pc:sldMk cId="524093625" sldId="265"/>
            <ac:spMk id="2" creationId="{990D40B6-0D71-4178-8977-A38747EB6705}"/>
          </ac:spMkLst>
        </pc:spChg>
        <pc:spChg chg="del">
          <ac:chgData name="Frances Byrne" userId="0d0641f6-b1a5-4b0a-9327-66807dc904a0" providerId="ADAL" clId="{C6E7C2F2-8BE3-47FE-8B1D-3AE2D45895C1}" dt="2022-01-28T05:37:54.939" v="8" actId="478"/>
          <ac:spMkLst>
            <pc:docMk/>
            <pc:sldMk cId="524093625" sldId="265"/>
            <ac:spMk id="3" creationId="{DA605E59-D2E9-42E7-B961-07940E910FBE}"/>
          </ac:spMkLst>
        </pc:spChg>
        <pc:spChg chg="add mod">
          <ac:chgData name="Frances Byrne" userId="0d0641f6-b1a5-4b0a-9327-66807dc904a0" providerId="ADAL" clId="{C6E7C2F2-8BE3-47FE-8B1D-3AE2D45895C1}" dt="2022-02-04T00:47:09.328" v="32" actId="1076"/>
          <ac:spMkLst>
            <pc:docMk/>
            <pc:sldMk cId="524093625" sldId="265"/>
            <ac:spMk id="5" creationId="{2854651C-B118-47E2-97A6-445C84AA0956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05FA5-395F-4F26-A5EF-27DB800E6477}" type="datetimeFigureOut">
              <a:rPr lang="en-AU" smtClean="0"/>
              <a:t>18/03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CA857-BC10-4930-8B1A-BF1B429F265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67365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05FA5-395F-4F26-A5EF-27DB800E6477}" type="datetimeFigureOut">
              <a:rPr lang="en-AU" smtClean="0"/>
              <a:t>18/03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CA857-BC10-4930-8B1A-BF1B429F265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45766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05FA5-395F-4F26-A5EF-27DB800E6477}" type="datetimeFigureOut">
              <a:rPr lang="en-AU" smtClean="0"/>
              <a:t>18/03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CA857-BC10-4930-8B1A-BF1B429F265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641629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05FA5-395F-4F26-A5EF-27DB800E6477}" type="datetimeFigureOut">
              <a:rPr lang="en-AU" smtClean="0"/>
              <a:t>18/03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CA857-BC10-4930-8B1A-BF1B429F265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48313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05FA5-395F-4F26-A5EF-27DB800E6477}" type="datetimeFigureOut">
              <a:rPr lang="en-AU" smtClean="0"/>
              <a:t>18/03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CA857-BC10-4930-8B1A-BF1B429F265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140728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05FA5-395F-4F26-A5EF-27DB800E6477}" type="datetimeFigureOut">
              <a:rPr lang="en-AU" smtClean="0"/>
              <a:t>18/03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CA857-BC10-4930-8B1A-BF1B429F265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901409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05FA5-395F-4F26-A5EF-27DB800E6477}" type="datetimeFigureOut">
              <a:rPr lang="en-AU" smtClean="0"/>
              <a:t>18/03/2022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CA857-BC10-4930-8B1A-BF1B429F265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990424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05FA5-395F-4F26-A5EF-27DB800E6477}" type="datetimeFigureOut">
              <a:rPr lang="en-AU" smtClean="0"/>
              <a:t>18/03/2022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CA857-BC10-4930-8B1A-BF1B429F265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022602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05FA5-395F-4F26-A5EF-27DB800E6477}" type="datetimeFigureOut">
              <a:rPr lang="en-AU" smtClean="0"/>
              <a:t>18/03/2022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CA857-BC10-4930-8B1A-BF1B429F265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335956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05FA5-395F-4F26-A5EF-27DB800E6477}" type="datetimeFigureOut">
              <a:rPr lang="en-AU" smtClean="0"/>
              <a:t>18/03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CA857-BC10-4930-8B1A-BF1B429F265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092498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05FA5-395F-4F26-A5EF-27DB800E6477}" type="datetimeFigureOut">
              <a:rPr lang="en-AU" smtClean="0"/>
              <a:t>18/03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CA857-BC10-4930-8B1A-BF1B429F265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19299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105FA5-395F-4F26-A5EF-27DB800E6477}" type="datetimeFigureOut">
              <a:rPr lang="en-AU" smtClean="0"/>
              <a:t>18/03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CCA857-BC10-4930-8B1A-BF1B429F265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501909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12.tif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tif"/><Relationship Id="rId5" Type="http://schemas.openxmlformats.org/officeDocument/2006/relationships/image" Target="../media/image10.tif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6919B0A-484E-4E36-94F8-95A166192186}"/>
              </a:ext>
            </a:extLst>
          </p:cNvPr>
          <p:cNvSpPr txBox="1"/>
          <p:nvPr/>
        </p:nvSpPr>
        <p:spPr>
          <a:xfrm>
            <a:off x="3329140" y="426935"/>
            <a:ext cx="505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561F07A-5BD2-4532-8AAD-C766B926C18F}"/>
              </a:ext>
            </a:extLst>
          </p:cNvPr>
          <p:cNvSpPr txBox="1"/>
          <p:nvPr/>
        </p:nvSpPr>
        <p:spPr>
          <a:xfrm>
            <a:off x="582436" y="3315030"/>
            <a:ext cx="505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261E7CD-FA48-4EE7-83A5-95609F242CE7}"/>
              </a:ext>
            </a:extLst>
          </p:cNvPr>
          <p:cNvSpPr txBox="1"/>
          <p:nvPr/>
        </p:nvSpPr>
        <p:spPr>
          <a:xfrm>
            <a:off x="4443475" y="3315030"/>
            <a:ext cx="505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5CAE9AFE-9CB8-464E-92CE-7C6BC2F6D9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21311" y="3575332"/>
            <a:ext cx="3883080" cy="266711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48F7CC1-AE7B-43EA-A7C4-DED0F2BE6F5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29144" y="3487800"/>
            <a:ext cx="2928235" cy="284218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71CB104B-FF01-4CD4-B3B9-B72C5719413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21311" y="6721217"/>
            <a:ext cx="3898898" cy="2667118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7D33F4C-F11E-4817-9FC1-2A20B53BC3A4}"/>
              </a:ext>
            </a:extLst>
          </p:cNvPr>
          <p:cNvSpPr txBox="1"/>
          <p:nvPr/>
        </p:nvSpPr>
        <p:spPr>
          <a:xfrm>
            <a:off x="582436" y="6295682"/>
            <a:ext cx="505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3916FE6-823D-4069-954C-DDE04E7C8765}"/>
              </a:ext>
            </a:extLst>
          </p:cNvPr>
          <p:cNvSpPr txBox="1"/>
          <p:nvPr/>
        </p:nvSpPr>
        <p:spPr>
          <a:xfrm>
            <a:off x="4443475" y="6295682"/>
            <a:ext cx="505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3DE28FDC-8CF1-40DE-B8D8-3940B94CE11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29144" y="6546153"/>
            <a:ext cx="2913100" cy="2842182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13317F7-128C-4980-9142-A986CB652E9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3627" r="10051" b="3126"/>
          <a:stretch/>
        </p:blipFill>
        <p:spPr>
          <a:xfrm>
            <a:off x="3329140" y="426935"/>
            <a:ext cx="2853010" cy="2842182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56D4FA59-FA5E-4DF0-B1D9-8018840DD176}"/>
              </a:ext>
            </a:extLst>
          </p:cNvPr>
          <p:cNvSpPr txBox="1"/>
          <p:nvPr/>
        </p:nvSpPr>
        <p:spPr>
          <a:xfrm>
            <a:off x="61992" y="2630"/>
            <a:ext cx="2791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Figure S1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D085B1C-65B5-4A69-8930-1010EC3E43D8}"/>
              </a:ext>
            </a:extLst>
          </p:cNvPr>
          <p:cNvSpPr txBox="1"/>
          <p:nvPr/>
        </p:nvSpPr>
        <p:spPr>
          <a:xfrm>
            <a:off x="392874" y="9604506"/>
            <a:ext cx="8863421" cy="24622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AU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Microbiota detection in samples versus the negative controls. A:</a:t>
            </a:r>
            <a:r>
              <a:rPr lang="en-A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Number of operational taxonomic units (OTUs) detected in the human and mouse samples compared to negative controls. Significance was tested using Kruskal Wallis with a Dunn’s multiple comparisons test. *** P&lt;0.001. </a:t>
            </a:r>
            <a:r>
              <a:rPr lang="en-AU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:</a:t>
            </a:r>
            <a:r>
              <a:rPr lang="en-A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incipal coordinate (PCO) analysis of beta diversity across human samples and controls. </a:t>
            </a:r>
            <a:r>
              <a:rPr lang="en-AU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: </a:t>
            </a:r>
            <a:r>
              <a:rPr lang="en-A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n-metric multidimensional scaling plot (</a:t>
            </a:r>
            <a:r>
              <a:rPr lang="en-AU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MDS</a:t>
            </a:r>
            <a:r>
              <a:rPr lang="en-A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of beta diversity across human samples and controls. </a:t>
            </a:r>
            <a:r>
              <a:rPr lang="en-AU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:</a:t>
            </a:r>
            <a:r>
              <a:rPr lang="en-A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incipal coordinate (PCO) analysis of beta diversity across mouse samples and controls. </a:t>
            </a:r>
            <a:r>
              <a:rPr lang="en-AU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: </a:t>
            </a:r>
            <a:r>
              <a:rPr lang="en-A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n-metric multidimensional scaling plot (</a:t>
            </a:r>
            <a:r>
              <a:rPr lang="en-AU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MDS</a:t>
            </a:r>
            <a:r>
              <a:rPr lang="en-A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of beta diversity across mouse samples and controls. All ordinations were generated from Bray-Curtis resemblance matrices on square-root transformed relative abundances of the relevant samples.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alysis of similarities (</a:t>
            </a:r>
            <a:r>
              <a:rPr lang="en-A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OSIM) was employed to test for significant differences in beta diversity. Six negative controls were tested in total; however, one was specific to the human samples and the other to the mouse samples.</a:t>
            </a:r>
          </a:p>
          <a:p>
            <a:pPr algn="just"/>
            <a:r>
              <a:rPr lang="en-A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30095079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4859D08-70E3-4347-ABF2-99E68E8487DD}"/>
              </a:ext>
            </a:extLst>
          </p:cNvPr>
          <p:cNvSpPr txBox="1"/>
          <p:nvPr/>
        </p:nvSpPr>
        <p:spPr>
          <a:xfrm>
            <a:off x="61992" y="2630"/>
            <a:ext cx="2791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Figure S2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D445544-0B77-49AB-8349-FE87A0231A50}"/>
              </a:ext>
            </a:extLst>
          </p:cNvPr>
          <p:cNvSpPr txBox="1"/>
          <p:nvPr/>
        </p:nvSpPr>
        <p:spPr>
          <a:xfrm>
            <a:off x="898902" y="4231037"/>
            <a:ext cx="4170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3E07812-3056-473B-B8E5-94C86B14A4AF}"/>
              </a:ext>
            </a:extLst>
          </p:cNvPr>
          <p:cNvSpPr txBox="1"/>
          <p:nvPr/>
        </p:nvSpPr>
        <p:spPr>
          <a:xfrm>
            <a:off x="4708902" y="4231037"/>
            <a:ext cx="4170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B960FE9D-1B16-4C58-B4FB-3F2A497CB7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3491" y="4469162"/>
            <a:ext cx="3810000" cy="27051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7E6A570F-2AA8-4756-94CF-DB685A8059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65575" y="4231037"/>
            <a:ext cx="3838575" cy="294322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1F1F3EE-6D09-42BD-AC5B-DE37DF75C1B4}"/>
              </a:ext>
            </a:extLst>
          </p:cNvPr>
          <p:cNvSpPr txBox="1"/>
          <p:nvPr/>
        </p:nvSpPr>
        <p:spPr>
          <a:xfrm>
            <a:off x="465221" y="7408322"/>
            <a:ext cx="8582525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</a:t>
            </a:r>
            <a:r>
              <a:rPr lang="en-AU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pha diversity measures of endometrial microbiota in humans. A: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rgalef’s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pecies richness,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: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ielou’s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pecies evenness across community types. Significance was tested using Kruskal Wallis with a Dunn’s multiple comparisons test. **P&lt;0.01, ***P&lt;0.001, ****P&lt;0.0001. </a:t>
            </a:r>
            <a:endParaRPr lang="en-AU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41848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Picture 37">
            <a:extLst>
              <a:ext uri="{FF2B5EF4-FFF2-40B4-BE49-F238E27FC236}">
                <a16:creationId xmlns:a16="http://schemas.microsoft.com/office/drawing/2014/main" id="{54C83C49-B1A8-4C3F-8BE9-BD0FB1F5447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10000"/>
                    </a14:imgEffect>
                    <a14:imgEffect>
                      <a14:brightnessContrast bright="15000" contrast="15000"/>
                    </a14:imgEffect>
                  </a14:imgLayer>
                </a14:imgProps>
              </a:ext>
            </a:extLst>
          </a:blip>
          <a:srcRect l="53058" t="37365" r="13554" b="27634"/>
          <a:stretch/>
        </p:blipFill>
        <p:spPr>
          <a:xfrm>
            <a:off x="2202509" y="567652"/>
            <a:ext cx="1955832" cy="2413591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AB4CF226-22C3-4AB4-8BB2-D534A4E4A45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10000"/>
                    </a14:imgEffect>
                    <a14:imgEffect>
                      <a14:brightnessContrast bright="26000" contrast="15000"/>
                    </a14:imgEffect>
                  </a14:imgLayer>
                </a14:imgProps>
              </a:ext>
            </a:extLst>
          </a:blip>
          <a:srcRect l="8578" t="37365" r="58034" b="27634"/>
          <a:stretch/>
        </p:blipFill>
        <p:spPr>
          <a:xfrm>
            <a:off x="5263120" y="567652"/>
            <a:ext cx="1955832" cy="2413591"/>
          </a:xfrm>
          <a:prstGeom prst="rect">
            <a:avLst/>
          </a:prstGeom>
        </p:spPr>
      </p:pic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7EE2CC85-C3CB-4E6E-BA51-7C387F434715}"/>
              </a:ext>
            </a:extLst>
          </p:cNvPr>
          <p:cNvCxnSpPr>
            <a:cxnSpLocks/>
          </p:cNvCxnSpPr>
          <p:nvPr/>
        </p:nvCxnSpPr>
        <p:spPr>
          <a:xfrm>
            <a:off x="5305278" y="2709275"/>
            <a:ext cx="86769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DAFA6394-6149-42DD-B958-DC3706091B7D}"/>
              </a:ext>
            </a:extLst>
          </p:cNvPr>
          <p:cNvSpPr txBox="1"/>
          <p:nvPr/>
        </p:nvSpPr>
        <p:spPr>
          <a:xfrm>
            <a:off x="5235533" y="254950"/>
            <a:ext cx="21034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Sprr2f-Cre;LKB1</a:t>
            </a:r>
            <a:r>
              <a:rPr lang="en-US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L/L</a:t>
            </a:r>
            <a:endParaRPr lang="en-AU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60FA00E-E9CD-4229-82BE-99EAA28CB248}"/>
              </a:ext>
            </a:extLst>
          </p:cNvPr>
          <p:cNvSpPr txBox="1"/>
          <p:nvPr/>
        </p:nvSpPr>
        <p:spPr>
          <a:xfrm>
            <a:off x="2720805" y="254951"/>
            <a:ext cx="10102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LKB1</a:t>
            </a:r>
            <a:r>
              <a:rPr lang="en-US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endParaRPr lang="en-AU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88B38A4-1FC9-42CA-A6E1-F9D9921E2309}"/>
              </a:ext>
            </a:extLst>
          </p:cNvPr>
          <p:cNvSpPr txBox="1"/>
          <p:nvPr/>
        </p:nvSpPr>
        <p:spPr>
          <a:xfrm>
            <a:off x="5256172" y="2685140"/>
            <a:ext cx="903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 cm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8394F28-36BF-4838-B7AE-CE7C914B85D7}"/>
              </a:ext>
            </a:extLst>
          </p:cNvPr>
          <p:cNvSpPr txBox="1"/>
          <p:nvPr/>
        </p:nvSpPr>
        <p:spPr>
          <a:xfrm>
            <a:off x="5895173" y="767941"/>
            <a:ext cx="7553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0.28 g</a:t>
            </a:r>
            <a:endParaRPr lang="en-AU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FA8B0CE-D461-4F99-8AA1-90C4BF8AD59F}"/>
              </a:ext>
            </a:extLst>
          </p:cNvPr>
          <p:cNvSpPr txBox="1"/>
          <p:nvPr/>
        </p:nvSpPr>
        <p:spPr>
          <a:xfrm>
            <a:off x="2791503" y="767942"/>
            <a:ext cx="7553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0.16 g</a:t>
            </a:r>
            <a:endParaRPr lang="en-AU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6642954-BDD2-41E8-BA24-FB39B9B0E1AC}"/>
              </a:ext>
            </a:extLst>
          </p:cNvPr>
          <p:cNvSpPr txBox="1"/>
          <p:nvPr/>
        </p:nvSpPr>
        <p:spPr>
          <a:xfrm>
            <a:off x="5326386" y="3208757"/>
            <a:ext cx="22802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Sprr2f-Cre;LKB1</a:t>
            </a:r>
            <a:r>
              <a:rPr lang="en-US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L/L</a:t>
            </a:r>
            <a:endParaRPr lang="en-AU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82CD6D1-BAF3-4E3B-8B8B-3E1CDC831FB0}"/>
              </a:ext>
            </a:extLst>
          </p:cNvPr>
          <p:cNvSpPr txBox="1"/>
          <p:nvPr/>
        </p:nvSpPr>
        <p:spPr>
          <a:xfrm>
            <a:off x="2654362" y="3208757"/>
            <a:ext cx="90593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LKB1</a:t>
            </a:r>
            <a:r>
              <a:rPr lang="en-US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endParaRPr lang="en-AU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Picture 34" descr="A close up of a cell phone&#10;&#10;Description automatically generated with low confidence">
            <a:extLst>
              <a:ext uri="{FF2B5EF4-FFF2-40B4-BE49-F238E27FC236}">
                <a16:creationId xmlns:a16="http://schemas.microsoft.com/office/drawing/2014/main" id="{5A04CD3E-F68E-48C9-B76B-12452DD1EEC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12" t="-164" r="25707" b="14525"/>
          <a:stretch/>
        </p:blipFill>
        <p:spPr>
          <a:xfrm rot="10800000">
            <a:off x="1705538" y="3544752"/>
            <a:ext cx="2802955" cy="2662686"/>
          </a:xfrm>
          <a:prstGeom prst="rect">
            <a:avLst/>
          </a:prstGeom>
        </p:spPr>
      </p:pic>
      <p:pic>
        <p:nvPicPr>
          <p:cNvPr id="37" name="Picture 36" descr="Background pattern&#10;&#10;Description automatically generated">
            <a:extLst>
              <a:ext uri="{FF2B5EF4-FFF2-40B4-BE49-F238E27FC236}">
                <a16:creationId xmlns:a16="http://schemas.microsoft.com/office/drawing/2014/main" id="{65E5458E-AF34-45CB-ABED-45FB714642B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1405" b="10700"/>
          <a:stretch/>
        </p:blipFill>
        <p:spPr>
          <a:xfrm rot="5400000">
            <a:off x="5127614" y="3487825"/>
            <a:ext cx="2662685" cy="2776543"/>
          </a:xfrm>
          <a:prstGeom prst="rect">
            <a:avLst/>
          </a:prstGeom>
        </p:spPr>
      </p:pic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E3606089-8807-4712-B16A-9A9E30755651}"/>
              </a:ext>
            </a:extLst>
          </p:cNvPr>
          <p:cNvCxnSpPr>
            <a:cxnSpLocks/>
          </p:cNvCxnSpPr>
          <p:nvPr/>
        </p:nvCxnSpPr>
        <p:spPr>
          <a:xfrm flipH="1">
            <a:off x="6417183" y="4442881"/>
            <a:ext cx="16078" cy="267254"/>
          </a:xfrm>
          <a:prstGeom prst="straightConnector1">
            <a:avLst/>
          </a:prstGeom>
          <a:ln w="571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D47FF96F-D58F-4151-9289-5713E50419AA}"/>
              </a:ext>
            </a:extLst>
          </p:cNvPr>
          <p:cNvCxnSpPr>
            <a:cxnSpLocks/>
          </p:cNvCxnSpPr>
          <p:nvPr/>
        </p:nvCxnSpPr>
        <p:spPr>
          <a:xfrm flipH="1">
            <a:off x="6348378" y="5110951"/>
            <a:ext cx="16078" cy="267254"/>
          </a:xfrm>
          <a:prstGeom prst="straightConnector1">
            <a:avLst/>
          </a:prstGeom>
          <a:ln w="571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Freeform: Shape 43">
            <a:extLst>
              <a:ext uri="{FF2B5EF4-FFF2-40B4-BE49-F238E27FC236}">
                <a16:creationId xmlns:a16="http://schemas.microsoft.com/office/drawing/2014/main" id="{2195B8C2-07C9-4A78-94BE-7CA7962DC60A}"/>
              </a:ext>
            </a:extLst>
          </p:cNvPr>
          <p:cNvSpPr/>
          <p:nvPr/>
        </p:nvSpPr>
        <p:spPr>
          <a:xfrm>
            <a:off x="6821129" y="3611030"/>
            <a:ext cx="601786" cy="2591889"/>
          </a:xfrm>
          <a:custGeom>
            <a:avLst/>
            <a:gdLst>
              <a:gd name="connsiteX0" fmla="*/ 671052 w 671052"/>
              <a:gd name="connsiteY0" fmla="*/ 0 h 2898058"/>
              <a:gd name="connsiteX1" fmla="*/ 663677 w 671052"/>
              <a:gd name="connsiteY1" fmla="*/ 582561 h 2898058"/>
              <a:gd name="connsiteX2" fmla="*/ 619432 w 671052"/>
              <a:gd name="connsiteY2" fmla="*/ 914400 h 2898058"/>
              <a:gd name="connsiteX3" fmla="*/ 575187 w 671052"/>
              <a:gd name="connsiteY3" fmla="*/ 1165123 h 2898058"/>
              <a:gd name="connsiteX4" fmla="*/ 516194 w 671052"/>
              <a:gd name="connsiteY4" fmla="*/ 1533832 h 2898058"/>
              <a:gd name="connsiteX5" fmla="*/ 464574 w 671052"/>
              <a:gd name="connsiteY5" fmla="*/ 1703439 h 2898058"/>
              <a:gd name="connsiteX6" fmla="*/ 449826 w 671052"/>
              <a:gd name="connsiteY6" fmla="*/ 1762432 h 2898058"/>
              <a:gd name="connsiteX7" fmla="*/ 442452 w 671052"/>
              <a:gd name="connsiteY7" fmla="*/ 1821426 h 2898058"/>
              <a:gd name="connsiteX8" fmla="*/ 398206 w 671052"/>
              <a:gd name="connsiteY8" fmla="*/ 1954161 h 2898058"/>
              <a:gd name="connsiteX9" fmla="*/ 383458 w 671052"/>
              <a:gd name="connsiteY9" fmla="*/ 2027903 h 2898058"/>
              <a:gd name="connsiteX10" fmla="*/ 361336 w 671052"/>
              <a:gd name="connsiteY10" fmla="*/ 2094271 h 2898058"/>
              <a:gd name="connsiteX11" fmla="*/ 287594 w 671052"/>
              <a:gd name="connsiteY11" fmla="*/ 2293374 h 2898058"/>
              <a:gd name="connsiteX12" fmla="*/ 221226 w 671052"/>
              <a:gd name="connsiteY12" fmla="*/ 2485103 h 2898058"/>
              <a:gd name="connsiteX13" fmla="*/ 184355 w 671052"/>
              <a:gd name="connsiteY13" fmla="*/ 2551471 h 2898058"/>
              <a:gd name="connsiteX14" fmla="*/ 140110 w 671052"/>
              <a:gd name="connsiteY14" fmla="*/ 2610464 h 2898058"/>
              <a:gd name="connsiteX15" fmla="*/ 117987 w 671052"/>
              <a:gd name="connsiteY15" fmla="*/ 2647335 h 2898058"/>
              <a:gd name="connsiteX16" fmla="*/ 110613 w 671052"/>
              <a:gd name="connsiteY16" fmla="*/ 2669458 h 2898058"/>
              <a:gd name="connsiteX17" fmla="*/ 95865 w 671052"/>
              <a:gd name="connsiteY17" fmla="*/ 2691581 h 2898058"/>
              <a:gd name="connsiteX18" fmla="*/ 81116 w 671052"/>
              <a:gd name="connsiteY18" fmla="*/ 2735826 h 2898058"/>
              <a:gd name="connsiteX19" fmla="*/ 51619 w 671052"/>
              <a:gd name="connsiteY19" fmla="*/ 2780071 h 2898058"/>
              <a:gd name="connsiteX20" fmla="*/ 29497 w 671052"/>
              <a:gd name="connsiteY20" fmla="*/ 2816942 h 2898058"/>
              <a:gd name="connsiteX21" fmla="*/ 0 w 671052"/>
              <a:gd name="connsiteY21" fmla="*/ 2883310 h 2898058"/>
              <a:gd name="connsiteX22" fmla="*/ 14748 w 671052"/>
              <a:gd name="connsiteY22" fmla="*/ 2898058 h 28980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</a:cxnLst>
            <a:rect l="l" t="t" r="r" b="b"/>
            <a:pathLst>
              <a:path w="671052" h="2898058">
                <a:moveTo>
                  <a:pt x="671052" y="0"/>
                </a:moveTo>
                <a:cubicBezTo>
                  <a:pt x="668594" y="194187"/>
                  <a:pt x="670865" y="388492"/>
                  <a:pt x="663677" y="582561"/>
                </a:cubicBezTo>
                <a:cubicBezTo>
                  <a:pt x="657430" y="751241"/>
                  <a:pt x="643600" y="773422"/>
                  <a:pt x="619432" y="914400"/>
                </a:cubicBezTo>
                <a:cubicBezTo>
                  <a:pt x="574651" y="1175622"/>
                  <a:pt x="619939" y="941368"/>
                  <a:pt x="575187" y="1165123"/>
                </a:cubicBezTo>
                <a:cubicBezTo>
                  <a:pt x="559552" y="1329290"/>
                  <a:pt x="562501" y="1357866"/>
                  <a:pt x="516194" y="1533832"/>
                </a:cubicBezTo>
                <a:cubicBezTo>
                  <a:pt x="476525" y="1684573"/>
                  <a:pt x="500921" y="1630747"/>
                  <a:pt x="464574" y="1703439"/>
                </a:cubicBezTo>
                <a:cubicBezTo>
                  <a:pt x="459658" y="1723103"/>
                  <a:pt x="453561" y="1742510"/>
                  <a:pt x="449826" y="1762432"/>
                </a:cubicBezTo>
                <a:cubicBezTo>
                  <a:pt x="446174" y="1781910"/>
                  <a:pt x="446751" y="1802080"/>
                  <a:pt x="442452" y="1821426"/>
                </a:cubicBezTo>
                <a:cubicBezTo>
                  <a:pt x="411340" y="1961428"/>
                  <a:pt x="431757" y="1833377"/>
                  <a:pt x="398206" y="1954161"/>
                </a:cubicBezTo>
                <a:cubicBezTo>
                  <a:pt x="391497" y="1978314"/>
                  <a:pt x="389837" y="2003661"/>
                  <a:pt x="383458" y="2027903"/>
                </a:cubicBezTo>
                <a:cubicBezTo>
                  <a:pt x="377524" y="2050455"/>
                  <a:pt x="369256" y="2072338"/>
                  <a:pt x="361336" y="2094271"/>
                </a:cubicBezTo>
                <a:cubicBezTo>
                  <a:pt x="337298" y="2160837"/>
                  <a:pt x="308408" y="2225730"/>
                  <a:pt x="287594" y="2293374"/>
                </a:cubicBezTo>
                <a:cubicBezTo>
                  <a:pt x="266209" y="2362874"/>
                  <a:pt x="251481" y="2418542"/>
                  <a:pt x="221226" y="2485103"/>
                </a:cubicBezTo>
                <a:cubicBezTo>
                  <a:pt x="210754" y="2508142"/>
                  <a:pt x="196264" y="2529141"/>
                  <a:pt x="184355" y="2551471"/>
                </a:cubicBezTo>
                <a:cubicBezTo>
                  <a:pt x="155571" y="2605441"/>
                  <a:pt x="177402" y="2585603"/>
                  <a:pt x="140110" y="2610464"/>
                </a:cubicBezTo>
                <a:cubicBezTo>
                  <a:pt x="132736" y="2622754"/>
                  <a:pt x="124397" y="2634515"/>
                  <a:pt x="117987" y="2647335"/>
                </a:cubicBezTo>
                <a:cubicBezTo>
                  <a:pt x="114511" y="2654288"/>
                  <a:pt x="114089" y="2662505"/>
                  <a:pt x="110613" y="2669458"/>
                </a:cubicBezTo>
                <a:cubicBezTo>
                  <a:pt x="106650" y="2677385"/>
                  <a:pt x="99465" y="2683482"/>
                  <a:pt x="95865" y="2691581"/>
                </a:cubicBezTo>
                <a:cubicBezTo>
                  <a:pt x="89551" y="2705787"/>
                  <a:pt x="88069" y="2721921"/>
                  <a:pt x="81116" y="2735826"/>
                </a:cubicBezTo>
                <a:cubicBezTo>
                  <a:pt x="73189" y="2751680"/>
                  <a:pt x="60738" y="2764872"/>
                  <a:pt x="51619" y="2780071"/>
                </a:cubicBezTo>
                <a:cubicBezTo>
                  <a:pt x="44245" y="2792361"/>
                  <a:pt x="36458" y="2804413"/>
                  <a:pt x="29497" y="2816942"/>
                </a:cubicBezTo>
                <a:cubicBezTo>
                  <a:pt x="24466" y="2825997"/>
                  <a:pt x="0" y="2875103"/>
                  <a:pt x="0" y="2883310"/>
                </a:cubicBezTo>
                <a:lnTo>
                  <a:pt x="14748" y="2898058"/>
                </a:lnTo>
              </a:path>
            </a:pathLst>
          </a:custGeom>
          <a:noFill/>
          <a:ln w="28575"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45" name="Freeform: Shape 44">
            <a:extLst>
              <a:ext uri="{FF2B5EF4-FFF2-40B4-BE49-F238E27FC236}">
                <a16:creationId xmlns:a16="http://schemas.microsoft.com/office/drawing/2014/main" id="{8B08D881-203D-4C8C-BDC9-39FCC60E0DF1}"/>
              </a:ext>
            </a:extLst>
          </p:cNvPr>
          <p:cNvSpPr/>
          <p:nvPr/>
        </p:nvSpPr>
        <p:spPr>
          <a:xfrm>
            <a:off x="2256503" y="3603657"/>
            <a:ext cx="1163893" cy="2578698"/>
          </a:xfrm>
          <a:custGeom>
            <a:avLst/>
            <a:gdLst>
              <a:gd name="connsiteX0" fmla="*/ 0 w 1297858"/>
              <a:gd name="connsiteY0" fmla="*/ 0 h 2883309"/>
              <a:gd name="connsiteX1" fmla="*/ 7374 w 1297858"/>
              <a:gd name="connsiteY1" fmla="*/ 228600 h 2883309"/>
              <a:gd name="connsiteX2" fmla="*/ 51620 w 1297858"/>
              <a:gd name="connsiteY2" fmla="*/ 486697 h 2883309"/>
              <a:gd name="connsiteX3" fmla="*/ 117987 w 1297858"/>
              <a:gd name="connsiteY3" fmla="*/ 781664 h 2883309"/>
              <a:gd name="connsiteX4" fmla="*/ 184355 w 1297858"/>
              <a:gd name="connsiteY4" fmla="*/ 1017638 h 2883309"/>
              <a:gd name="connsiteX5" fmla="*/ 317091 w 1297858"/>
              <a:gd name="connsiteY5" fmla="*/ 1275735 h 2883309"/>
              <a:gd name="connsiteX6" fmla="*/ 383458 w 1297858"/>
              <a:gd name="connsiteY6" fmla="*/ 1430593 h 2883309"/>
              <a:gd name="connsiteX7" fmla="*/ 486697 w 1297858"/>
              <a:gd name="connsiteY7" fmla="*/ 1622322 h 2883309"/>
              <a:gd name="connsiteX8" fmla="*/ 656303 w 1297858"/>
              <a:gd name="connsiteY8" fmla="*/ 1880419 h 2883309"/>
              <a:gd name="connsiteX9" fmla="*/ 744794 w 1297858"/>
              <a:gd name="connsiteY9" fmla="*/ 2064774 h 2883309"/>
              <a:gd name="connsiteX10" fmla="*/ 781665 w 1297858"/>
              <a:gd name="connsiteY10" fmla="*/ 2138516 h 2883309"/>
              <a:gd name="connsiteX11" fmla="*/ 796413 w 1297858"/>
              <a:gd name="connsiteY11" fmla="*/ 2168013 h 2883309"/>
              <a:gd name="connsiteX12" fmla="*/ 833284 w 1297858"/>
              <a:gd name="connsiteY12" fmla="*/ 2227006 h 2883309"/>
              <a:gd name="connsiteX13" fmla="*/ 973394 w 1297858"/>
              <a:gd name="connsiteY13" fmla="*/ 2389238 h 2883309"/>
              <a:gd name="connsiteX14" fmla="*/ 988142 w 1297858"/>
              <a:gd name="connsiteY14" fmla="*/ 2426109 h 2883309"/>
              <a:gd name="connsiteX15" fmla="*/ 1010265 w 1297858"/>
              <a:gd name="connsiteY15" fmla="*/ 2440858 h 2883309"/>
              <a:gd name="connsiteX16" fmla="*/ 1032387 w 1297858"/>
              <a:gd name="connsiteY16" fmla="*/ 2470355 h 2883309"/>
              <a:gd name="connsiteX17" fmla="*/ 1091381 w 1297858"/>
              <a:gd name="connsiteY17" fmla="*/ 2529348 h 2883309"/>
              <a:gd name="connsiteX18" fmla="*/ 1150374 w 1297858"/>
              <a:gd name="connsiteY18" fmla="*/ 2632587 h 2883309"/>
              <a:gd name="connsiteX19" fmla="*/ 1179871 w 1297858"/>
              <a:gd name="connsiteY19" fmla="*/ 2684206 h 2883309"/>
              <a:gd name="connsiteX20" fmla="*/ 1187245 w 1297858"/>
              <a:gd name="connsiteY20" fmla="*/ 2713703 h 2883309"/>
              <a:gd name="connsiteX21" fmla="*/ 1231491 w 1297858"/>
              <a:gd name="connsiteY21" fmla="*/ 2787445 h 2883309"/>
              <a:gd name="connsiteX22" fmla="*/ 1246239 w 1297858"/>
              <a:gd name="connsiteY22" fmla="*/ 2816942 h 2883309"/>
              <a:gd name="connsiteX23" fmla="*/ 1297858 w 1297858"/>
              <a:gd name="connsiteY23" fmla="*/ 2883309 h 288330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</a:cxnLst>
            <a:rect l="l" t="t" r="r" b="b"/>
            <a:pathLst>
              <a:path w="1297858" h="2883309">
                <a:moveTo>
                  <a:pt x="0" y="0"/>
                </a:moveTo>
                <a:cubicBezTo>
                  <a:pt x="2458" y="76200"/>
                  <a:pt x="2517" y="152515"/>
                  <a:pt x="7374" y="228600"/>
                </a:cubicBezTo>
                <a:cubicBezTo>
                  <a:pt x="14123" y="334337"/>
                  <a:pt x="30719" y="379580"/>
                  <a:pt x="51620" y="486697"/>
                </a:cubicBezTo>
                <a:cubicBezTo>
                  <a:pt x="135883" y="918550"/>
                  <a:pt x="27512" y="408458"/>
                  <a:pt x="117987" y="781664"/>
                </a:cubicBezTo>
                <a:cubicBezTo>
                  <a:pt x="151593" y="920287"/>
                  <a:pt x="124305" y="875019"/>
                  <a:pt x="184355" y="1017638"/>
                </a:cubicBezTo>
                <a:cubicBezTo>
                  <a:pt x="319274" y="1338071"/>
                  <a:pt x="199134" y="1032882"/>
                  <a:pt x="317091" y="1275735"/>
                </a:cubicBezTo>
                <a:cubicBezTo>
                  <a:pt x="341628" y="1326251"/>
                  <a:pt x="353089" y="1383352"/>
                  <a:pt x="383458" y="1430593"/>
                </a:cubicBezTo>
                <a:cubicBezTo>
                  <a:pt x="510001" y="1627437"/>
                  <a:pt x="400586" y="1443950"/>
                  <a:pt x="486697" y="1622322"/>
                </a:cubicBezTo>
                <a:cubicBezTo>
                  <a:pt x="637174" y="1934024"/>
                  <a:pt x="455418" y="1548186"/>
                  <a:pt x="656303" y="1880419"/>
                </a:cubicBezTo>
                <a:cubicBezTo>
                  <a:pt x="691573" y="1938749"/>
                  <a:pt x="715013" y="2003460"/>
                  <a:pt x="744794" y="2064774"/>
                </a:cubicBezTo>
                <a:cubicBezTo>
                  <a:pt x="756801" y="2089494"/>
                  <a:pt x="769375" y="2113935"/>
                  <a:pt x="781665" y="2138516"/>
                </a:cubicBezTo>
                <a:cubicBezTo>
                  <a:pt x="786581" y="2148348"/>
                  <a:pt x="790587" y="2158691"/>
                  <a:pt x="796413" y="2168013"/>
                </a:cubicBezTo>
                <a:cubicBezTo>
                  <a:pt x="808703" y="2187677"/>
                  <a:pt x="818798" y="2208898"/>
                  <a:pt x="833284" y="2227006"/>
                </a:cubicBezTo>
                <a:cubicBezTo>
                  <a:pt x="877921" y="2282801"/>
                  <a:pt x="973394" y="2389238"/>
                  <a:pt x="973394" y="2389238"/>
                </a:cubicBezTo>
                <a:cubicBezTo>
                  <a:pt x="978310" y="2401528"/>
                  <a:pt x="980448" y="2415338"/>
                  <a:pt x="988142" y="2426109"/>
                </a:cubicBezTo>
                <a:cubicBezTo>
                  <a:pt x="993293" y="2433321"/>
                  <a:pt x="1003998" y="2434591"/>
                  <a:pt x="1010265" y="2440858"/>
                </a:cubicBezTo>
                <a:cubicBezTo>
                  <a:pt x="1018955" y="2449549"/>
                  <a:pt x="1024082" y="2461295"/>
                  <a:pt x="1032387" y="2470355"/>
                </a:cubicBezTo>
                <a:cubicBezTo>
                  <a:pt x="1051179" y="2490855"/>
                  <a:pt x="1078944" y="2504474"/>
                  <a:pt x="1091381" y="2529348"/>
                </a:cubicBezTo>
                <a:cubicBezTo>
                  <a:pt x="1154658" y="2655902"/>
                  <a:pt x="1087840" y="2528363"/>
                  <a:pt x="1150374" y="2632587"/>
                </a:cubicBezTo>
                <a:cubicBezTo>
                  <a:pt x="1206501" y="2726133"/>
                  <a:pt x="1128862" y="2607692"/>
                  <a:pt x="1179871" y="2684206"/>
                </a:cubicBezTo>
                <a:cubicBezTo>
                  <a:pt x="1182329" y="2694038"/>
                  <a:pt x="1183686" y="2704213"/>
                  <a:pt x="1187245" y="2713703"/>
                </a:cubicBezTo>
                <a:cubicBezTo>
                  <a:pt x="1198482" y="2743669"/>
                  <a:pt x="1214341" y="2758861"/>
                  <a:pt x="1231491" y="2787445"/>
                </a:cubicBezTo>
                <a:cubicBezTo>
                  <a:pt x="1237147" y="2796871"/>
                  <a:pt x="1240141" y="2807795"/>
                  <a:pt x="1246239" y="2816942"/>
                </a:cubicBezTo>
                <a:cubicBezTo>
                  <a:pt x="1277125" y="2863271"/>
                  <a:pt x="1275287" y="2860738"/>
                  <a:pt x="1297858" y="2883309"/>
                </a:cubicBezTo>
              </a:path>
            </a:pathLst>
          </a:custGeom>
          <a:noFill/>
          <a:ln w="28575"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54136F6A-A28A-4FB8-A1A4-5834B83939F8}"/>
              </a:ext>
            </a:extLst>
          </p:cNvPr>
          <p:cNvCxnSpPr>
            <a:cxnSpLocks/>
          </p:cNvCxnSpPr>
          <p:nvPr/>
        </p:nvCxnSpPr>
        <p:spPr>
          <a:xfrm flipH="1">
            <a:off x="6235160" y="5631651"/>
            <a:ext cx="31881" cy="179180"/>
          </a:xfrm>
          <a:prstGeom prst="straightConnector1">
            <a:avLst/>
          </a:prstGeom>
          <a:ln w="571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880FDB3D-ABB6-40B8-A4F0-AB1FF867BAF2}"/>
              </a:ext>
            </a:extLst>
          </p:cNvPr>
          <p:cNvCxnSpPr>
            <a:cxnSpLocks/>
          </p:cNvCxnSpPr>
          <p:nvPr/>
        </p:nvCxnSpPr>
        <p:spPr>
          <a:xfrm flipH="1">
            <a:off x="6068777" y="6022833"/>
            <a:ext cx="16078" cy="267254"/>
          </a:xfrm>
          <a:prstGeom prst="straightConnector1">
            <a:avLst/>
          </a:prstGeom>
          <a:ln w="571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D3546A1A-8BC7-4045-97C6-069BF6723B23}"/>
              </a:ext>
            </a:extLst>
          </p:cNvPr>
          <p:cNvCxnSpPr>
            <a:cxnSpLocks/>
          </p:cNvCxnSpPr>
          <p:nvPr/>
        </p:nvCxnSpPr>
        <p:spPr>
          <a:xfrm flipH="1" flipV="1">
            <a:off x="6335116" y="3994754"/>
            <a:ext cx="8775" cy="31810"/>
          </a:xfrm>
          <a:prstGeom prst="straightConnector1">
            <a:avLst/>
          </a:prstGeom>
          <a:ln w="571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B6279FF9-8E22-49EE-99B1-DBC2674436EF}"/>
              </a:ext>
            </a:extLst>
          </p:cNvPr>
          <p:cNvCxnSpPr>
            <a:cxnSpLocks/>
          </p:cNvCxnSpPr>
          <p:nvPr/>
        </p:nvCxnSpPr>
        <p:spPr>
          <a:xfrm>
            <a:off x="1732095" y="6504334"/>
            <a:ext cx="102158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31C3A3E4-3354-4D6C-89FF-1911034EFB9A}"/>
              </a:ext>
            </a:extLst>
          </p:cNvPr>
          <p:cNvSpPr txBox="1"/>
          <p:nvPr/>
        </p:nvSpPr>
        <p:spPr>
          <a:xfrm>
            <a:off x="1629910" y="6227335"/>
            <a:ext cx="1149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00 µm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BE7C3513-B5E2-4629-855F-9F9EADF3D49D}"/>
              </a:ext>
            </a:extLst>
          </p:cNvPr>
          <p:cNvSpPr txBox="1"/>
          <p:nvPr/>
        </p:nvSpPr>
        <p:spPr>
          <a:xfrm>
            <a:off x="89898" y="31054"/>
            <a:ext cx="2791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Figure S3 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B761B40-3161-44B1-A1B6-B53A5DC17589}"/>
              </a:ext>
            </a:extLst>
          </p:cNvPr>
          <p:cNvSpPr txBox="1"/>
          <p:nvPr/>
        </p:nvSpPr>
        <p:spPr>
          <a:xfrm>
            <a:off x="1665372" y="254950"/>
            <a:ext cx="4170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5993982-7B5C-44C8-B4FB-D97BC7741D28}"/>
              </a:ext>
            </a:extLst>
          </p:cNvPr>
          <p:cNvSpPr txBox="1"/>
          <p:nvPr/>
        </p:nvSpPr>
        <p:spPr>
          <a:xfrm>
            <a:off x="1231106" y="3175420"/>
            <a:ext cx="3740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AU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Picture 29" descr="A picture containing ocean floor&#10;&#10;Description automatically generated">
            <a:extLst>
              <a:ext uri="{FF2B5EF4-FFF2-40B4-BE49-F238E27FC236}">
                <a16:creationId xmlns:a16="http://schemas.microsoft.com/office/drawing/2014/main" id="{14AE4C4B-A48C-42D5-885D-EB52437000DB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1269"/>
          <a:stretch/>
        </p:blipFill>
        <p:spPr>
          <a:xfrm>
            <a:off x="1901430" y="6932234"/>
            <a:ext cx="5798339" cy="3520187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6880DEF3-6FE3-4751-A70F-891109D4E14F}"/>
              </a:ext>
            </a:extLst>
          </p:cNvPr>
          <p:cNvSpPr txBox="1"/>
          <p:nvPr/>
        </p:nvSpPr>
        <p:spPr>
          <a:xfrm>
            <a:off x="3522814" y="6584370"/>
            <a:ext cx="2554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Sprr2f-Cre;LKB1</a:t>
            </a:r>
            <a:r>
              <a:rPr lang="en-US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L/L</a:t>
            </a:r>
            <a:endParaRPr lang="en-AU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69AB743-177A-4E6E-82F4-A5DB76A7B681}"/>
              </a:ext>
            </a:extLst>
          </p:cNvPr>
          <p:cNvSpPr txBox="1"/>
          <p:nvPr/>
        </p:nvSpPr>
        <p:spPr>
          <a:xfrm>
            <a:off x="1231106" y="6872949"/>
            <a:ext cx="3740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AU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CB7F2044-2B4B-4680-A161-7D9E964F184A}"/>
              </a:ext>
            </a:extLst>
          </p:cNvPr>
          <p:cNvCxnSpPr>
            <a:cxnSpLocks/>
          </p:cNvCxnSpPr>
          <p:nvPr/>
        </p:nvCxnSpPr>
        <p:spPr>
          <a:xfrm>
            <a:off x="1830908" y="10738276"/>
            <a:ext cx="129716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8A8BE13D-322C-428E-8B9A-0AA1B5DC75CC}"/>
              </a:ext>
            </a:extLst>
          </p:cNvPr>
          <p:cNvSpPr txBox="1"/>
          <p:nvPr/>
        </p:nvSpPr>
        <p:spPr>
          <a:xfrm>
            <a:off x="2047950" y="10454243"/>
            <a:ext cx="8332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60 µm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6A8A4DF-BAFC-4DD6-A30D-E6B098332B7B}"/>
              </a:ext>
            </a:extLst>
          </p:cNvPr>
          <p:cNvSpPr txBox="1"/>
          <p:nvPr/>
        </p:nvSpPr>
        <p:spPr>
          <a:xfrm>
            <a:off x="2506681" y="3631035"/>
            <a:ext cx="109303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yometrium</a:t>
            </a:r>
            <a:endParaRPr lang="en-AU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AA0C3F8-3C85-465A-A953-9D683B01A989}"/>
              </a:ext>
            </a:extLst>
          </p:cNvPr>
          <p:cNvSpPr txBox="1"/>
          <p:nvPr/>
        </p:nvSpPr>
        <p:spPr>
          <a:xfrm>
            <a:off x="6304674" y="3658105"/>
            <a:ext cx="1014611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yometrium</a:t>
            </a:r>
            <a:endParaRPr lang="en-AU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564EA12-E43D-4EFF-9650-FF97A97594F1}"/>
              </a:ext>
            </a:extLst>
          </p:cNvPr>
          <p:cNvSpPr txBox="1"/>
          <p:nvPr/>
        </p:nvSpPr>
        <p:spPr>
          <a:xfrm>
            <a:off x="465221" y="10877467"/>
            <a:ext cx="8742947" cy="16004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</a:t>
            </a:r>
            <a:r>
              <a:rPr lang="en-AU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idation of the </a:t>
            </a:r>
            <a:r>
              <a:rPr lang="en-US" sz="14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rr2f-Cre: LKB1</a:t>
            </a:r>
            <a:r>
              <a:rPr lang="en-US" sz="1400" b="1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/L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ouse model of endometrial cancer backcrossed to C57BL/6J mice.</a:t>
            </a:r>
            <a:r>
              <a:rPr lang="en-AU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: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terus from a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rr2f-Cre: LKB1</a:t>
            </a:r>
            <a:r>
              <a:rPr lang="en-US" sz="1400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/L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57BL/6J mouse is enlarged compared with a wildtype littermate (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KB1</a:t>
            </a:r>
            <a:r>
              <a:rPr lang="en-US" sz="1400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/+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mice at the same age (16 weeks old). Uteri weights are written in text on the images.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: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&amp;E-stained slides of mouse uteri. Histology is normal in a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KB1</a:t>
            </a:r>
            <a:r>
              <a:rPr lang="en-US" sz="1400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/+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use, where endometrial glands remain in the stroma. In comparison, endometrial glands are invading the myometrium (shown with yellow arrows) in a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rr2f-Cre: LKB1</a:t>
            </a:r>
            <a:r>
              <a:rPr lang="en-US" sz="1400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/L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use.</a:t>
            </a:r>
            <a:r>
              <a:rPr lang="en-US" sz="1400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th mice were ~ 36 weeks old. Scale bar = 300 µm.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: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igh resolution image showing crowded endometrial glands (indicative of cancer) in the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rr2f-Cre: LKB1</a:t>
            </a:r>
            <a:r>
              <a:rPr lang="en-US" sz="1400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/L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use from Figure S2B. Scale bar = 60 µm.</a:t>
            </a:r>
            <a:endParaRPr lang="en-AU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53712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69EE20F-8F24-4CF8-AE6F-5459587327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1345" y="2681252"/>
            <a:ext cx="3810000" cy="27051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909B00D-56E5-4249-85E9-2AF7EB295A4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664"/>
          <a:stretch/>
        </p:blipFill>
        <p:spPr>
          <a:xfrm>
            <a:off x="4830929" y="2435106"/>
            <a:ext cx="3838575" cy="295124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A438D1B-F5E7-4682-8542-11699FA23CE4}"/>
              </a:ext>
            </a:extLst>
          </p:cNvPr>
          <p:cNvSpPr txBox="1"/>
          <p:nvPr/>
        </p:nvSpPr>
        <p:spPr>
          <a:xfrm>
            <a:off x="831132" y="2322811"/>
            <a:ext cx="4170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A0A7D16-0E0D-4D58-8329-E1C60363BD34}"/>
              </a:ext>
            </a:extLst>
          </p:cNvPr>
          <p:cNvSpPr txBox="1"/>
          <p:nvPr/>
        </p:nvSpPr>
        <p:spPr>
          <a:xfrm>
            <a:off x="4547088" y="2322811"/>
            <a:ext cx="4170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C7767EC-D1AF-4CFC-A3DE-CBA8073A2747}"/>
              </a:ext>
            </a:extLst>
          </p:cNvPr>
          <p:cNvSpPr txBox="1"/>
          <p:nvPr/>
        </p:nvSpPr>
        <p:spPr>
          <a:xfrm>
            <a:off x="831132" y="5461551"/>
            <a:ext cx="4170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24797C1-4C7C-437F-8CED-D4E72DCD042D}"/>
              </a:ext>
            </a:extLst>
          </p:cNvPr>
          <p:cNvSpPr txBox="1"/>
          <p:nvPr/>
        </p:nvSpPr>
        <p:spPr>
          <a:xfrm>
            <a:off x="4547088" y="5461551"/>
            <a:ext cx="4170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59E9B30E-4254-4FC0-8549-A5CAAA31A03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0469" y="5902889"/>
            <a:ext cx="3810000" cy="237120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90F4837-85C5-42DF-9900-14FDCCF2815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54741" y="5638013"/>
            <a:ext cx="3790950" cy="27051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27846C14-95C6-412B-B622-CEF34062EF1D}"/>
              </a:ext>
            </a:extLst>
          </p:cNvPr>
          <p:cNvSpPr txBox="1"/>
          <p:nvPr/>
        </p:nvSpPr>
        <p:spPr>
          <a:xfrm>
            <a:off x="61992" y="0"/>
            <a:ext cx="2791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Figure S4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771DBBF-DA4C-485C-A79D-C390D6B0DB0F}"/>
              </a:ext>
            </a:extLst>
          </p:cNvPr>
          <p:cNvSpPr txBox="1"/>
          <p:nvPr/>
        </p:nvSpPr>
        <p:spPr>
          <a:xfrm>
            <a:off x="433137" y="8905479"/>
            <a:ext cx="8742947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4</a:t>
            </a:r>
            <a:r>
              <a:rPr lang="en-AU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dometrial microbiota of mice on chow or a western diet. A: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rgalef’s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pecies richness,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: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ielou’s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pecies evenness across community types. Significance was tested using Kruskal Wallis with a Dunn’s multiple comparisons test. **P&lt;0.01, ****P&lt;0.0001.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: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iet intake across community types. WD: Western diet.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: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ody weight at endpoint across community types.</a:t>
            </a:r>
            <a:endParaRPr lang="en-AU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14333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50</TotalTime>
  <Words>530</Words>
  <Application>Microsoft Office PowerPoint</Application>
  <PresentationFormat>A3 Paper (297x420 mm)</PresentationFormat>
  <Paragraphs>3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deem Kaakoush;Frances Byrne</dc:creator>
  <cp:lastModifiedBy>Frances Byrne</cp:lastModifiedBy>
  <cp:revision>17</cp:revision>
  <dcterms:created xsi:type="dcterms:W3CDTF">2021-12-06T04:12:13Z</dcterms:created>
  <dcterms:modified xsi:type="dcterms:W3CDTF">2022-03-18T01:31:33Z</dcterms:modified>
</cp:coreProperties>
</file>